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5" r:id="rId2"/>
    <p:sldId id="348" r:id="rId3"/>
    <p:sldId id="349" r:id="rId4"/>
    <p:sldId id="350" r:id="rId5"/>
    <p:sldId id="352" r:id="rId6"/>
    <p:sldId id="357" r:id="rId7"/>
    <p:sldId id="353" r:id="rId8"/>
    <p:sldId id="361" r:id="rId9"/>
    <p:sldId id="362" r:id="rId10"/>
    <p:sldId id="364" r:id="rId11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650" userDrawn="1">
          <p15:clr>
            <a:srgbClr val="A4A3A4"/>
          </p15:clr>
        </p15:guide>
        <p15:guide id="3" pos="64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4660"/>
  </p:normalViewPr>
  <p:slideViewPr>
    <p:cSldViewPr snapToGrid="0">
      <p:cViewPr varScale="1">
        <p:scale>
          <a:sx n="74" d="100"/>
          <a:sy n="74" d="100"/>
        </p:scale>
        <p:origin x="486" y="90"/>
      </p:cViewPr>
      <p:guideLst>
        <p:guide orient="horz" pos="2160"/>
        <p:guide pos="4650"/>
        <p:guide pos="64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igur\Dropbox\My%20PC%20(LAPTOP-O6TMU9QV)\Desktop\Tokyo\&#9733;&#9733;%20&#20849;&#33879;\forest%20plot%20SGLT2%20All-Cause%20Death%20020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32000000000000006</c:v>
                  </c:pt>
                  <c:pt idx="4">
                    <c:v>0.24</c:v>
                  </c:pt>
                  <c:pt idx="5">
                    <c:v>0.17000000000000004</c:v>
                  </c:pt>
                  <c:pt idx="6">
                    <c:v>0</c:v>
                  </c:pt>
                  <c:pt idx="7">
                    <c:v>0</c:v>
                  </c:pt>
                  <c:pt idx="8">
                    <c:v>0.55000000000000004</c:v>
                  </c:pt>
                  <c:pt idx="9">
                    <c:v>0.63</c:v>
                  </c:pt>
                  <c:pt idx="10">
                    <c:v>0.38000000000000012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34000000000000008</c:v>
                  </c:pt>
                  <c:pt idx="14">
                    <c:v>0.32000000000000006</c:v>
                  </c:pt>
                  <c:pt idx="15">
                    <c:v>0.24999999999999989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59000000000000008</c:v>
                  </c:pt>
                  <c:pt idx="19">
                    <c:v>0.44999999999999996</c:v>
                  </c:pt>
                  <c:pt idx="20">
                    <c:v>0.39000000000000012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48000000000000009</c:v>
                  </c:pt>
                  <c:pt idx="24">
                    <c:v>0.68</c:v>
                  </c:pt>
                  <c:pt idx="25">
                    <c:v>0.34000000000000008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19999999999999996</c:v>
                  </c:pt>
                  <c:pt idx="4">
                    <c:v>0.2400000000000001</c:v>
                  </c:pt>
                  <c:pt idx="5">
                    <c:v>0.17000000000000004</c:v>
                  </c:pt>
                  <c:pt idx="6">
                    <c:v>0</c:v>
                  </c:pt>
                  <c:pt idx="7">
                    <c:v>0</c:v>
                  </c:pt>
                  <c:pt idx="8">
                    <c:v>0.34</c:v>
                  </c:pt>
                  <c:pt idx="9">
                    <c:v>0.39</c:v>
                  </c:pt>
                  <c:pt idx="10">
                    <c:v>0.2799999999999999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0999999999999996</c:v>
                  </c:pt>
                  <c:pt idx="14">
                    <c:v>0.21999999999999997</c:v>
                  </c:pt>
                  <c:pt idx="15">
                    <c:v>0.17000000000000004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30999999999999994</c:v>
                  </c:pt>
                  <c:pt idx="19">
                    <c:v>0.30999999999999994</c:v>
                  </c:pt>
                  <c:pt idx="20">
                    <c:v>0.2599999999999999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27999999999999997</c:v>
                  </c:pt>
                  <c:pt idx="24">
                    <c:v>0.37</c:v>
                  </c:pt>
                  <c:pt idx="25">
                    <c:v>0.28999999999999998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" formatCode="0.00">
                  <c:v>1</c:v>
                </c:pt>
                <c:pt idx="3" formatCode="0.00">
                  <c:v>0.95</c:v>
                </c:pt>
                <c:pt idx="4" formatCode="0.00">
                  <c:v>1.1100000000000001</c:v>
                </c:pt>
                <c:pt idx="5" formatCode="0.00">
                  <c:v>0.9</c:v>
                </c:pt>
                <c:pt idx="7" formatCode="0.00">
                  <c:v>1</c:v>
                </c:pt>
                <c:pt idx="8" formatCode="0.00">
                  <c:v>0.78</c:v>
                </c:pt>
                <c:pt idx="9" formatCode="0.00">
                  <c:v>0.89</c:v>
                </c:pt>
                <c:pt idx="10" formatCode="0.00">
                  <c:v>0.73</c:v>
                </c:pt>
                <c:pt idx="12" formatCode="0.00">
                  <c:v>1</c:v>
                </c:pt>
                <c:pt idx="13" formatCode="0.00">
                  <c:v>0.96</c:v>
                </c:pt>
                <c:pt idx="14" formatCode="0.00">
                  <c:v>0.99</c:v>
                </c:pt>
                <c:pt idx="15" formatCode="0.00">
                  <c:v>0.92</c:v>
                </c:pt>
                <c:pt idx="17" formatCode="0.00">
                  <c:v>1</c:v>
                </c:pt>
                <c:pt idx="18" formatCode="0.00">
                  <c:v>0.97</c:v>
                </c:pt>
                <c:pt idx="19" formatCode="0.00">
                  <c:v>0.95</c:v>
                </c:pt>
                <c:pt idx="20" formatCode="0.00">
                  <c:v>0.94</c:v>
                </c:pt>
                <c:pt idx="22" formatCode="0.00">
                  <c:v>1</c:v>
                </c:pt>
                <c:pt idx="23" formatCode="0.00">
                  <c:v>0.61</c:v>
                </c:pt>
                <c:pt idx="24" formatCode="0.00">
                  <c:v>0.85</c:v>
                </c:pt>
                <c:pt idx="25">
                  <c:v>0.75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">
                  <c:v>49</c:v>
                </c:pt>
                <c:pt idx="2">
                  <c:v>47</c:v>
                </c:pt>
                <c:pt idx="3">
                  <c:v>45</c:v>
                </c:pt>
                <c:pt idx="4">
                  <c:v>43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389-46B8-946A-C32A08462B60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389-46B8-946A-C32A08462B60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389-46B8-946A-C32A08462B60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8389-46B8-946A-C32A08462B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61152"/>
        <c:axId val="498661696"/>
      </c:scatterChart>
      <c:valAx>
        <c:axId val="498661152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61696"/>
        <c:crosses val="autoZero"/>
        <c:crossBetween val="midCat"/>
        <c:majorUnit val="0.5"/>
      </c:valAx>
      <c:valAx>
        <c:axId val="498661696"/>
        <c:scaling>
          <c:orientation val="minMax"/>
          <c:max val="49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611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6</c:v>
                  </c:pt>
                  <c:pt idx="4">
                    <c:v>0.28000000000000003</c:v>
                  </c:pt>
                  <c:pt idx="5">
                    <c:v>0.19000000000000006</c:v>
                  </c:pt>
                  <c:pt idx="6">
                    <c:v>0</c:v>
                  </c:pt>
                  <c:pt idx="7">
                    <c:v>0</c:v>
                  </c:pt>
                  <c:pt idx="8">
                    <c:v>0.53</c:v>
                  </c:pt>
                  <c:pt idx="9">
                    <c:v>0.59000000000000008</c:v>
                  </c:pt>
                  <c:pt idx="10">
                    <c:v>0.39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9000000000000004</c:v>
                  </c:pt>
                  <c:pt idx="14">
                    <c:v>0.28000000000000003</c:v>
                  </c:pt>
                  <c:pt idx="15">
                    <c:v>0.21999999999999997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52</c:v>
                  </c:pt>
                  <c:pt idx="19">
                    <c:v>0.51</c:v>
                  </c:pt>
                  <c:pt idx="20">
                    <c:v>0.3899999999999999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47000000000000008</c:v>
                  </c:pt>
                  <c:pt idx="24">
                    <c:v>0.62</c:v>
                  </c:pt>
                  <c:pt idx="25">
                    <c:v>0.4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19999999999999996</c:v>
                  </c:pt>
                  <c:pt idx="4">
                    <c:v>0.22000000000000008</c:v>
                  </c:pt>
                  <c:pt idx="5">
                    <c:v>0.16000000000000003</c:v>
                  </c:pt>
                  <c:pt idx="6">
                    <c:v>0</c:v>
                  </c:pt>
                  <c:pt idx="7">
                    <c:v>0</c:v>
                  </c:pt>
                  <c:pt idx="8">
                    <c:v>0.31</c:v>
                  </c:pt>
                  <c:pt idx="9">
                    <c:v>0.33</c:v>
                  </c:pt>
                  <c:pt idx="10">
                    <c:v>0.24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2000000000000008</c:v>
                  </c:pt>
                  <c:pt idx="14">
                    <c:v>0.20999999999999996</c:v>
                  </c:pt>
                  <c:pt idx="15">
                    <c:v>0.17999999999999994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34999999999999987</c:v>
                  </c:pt>
                  <c:pt idx="19">
                    <c:v>0.34000000000000008</c:v>
                  </c:pt>
                  <c:pt idx="20">
                    <c:v>0.28000000000000003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25999999999999995</c:v>
                  </c:pt>
                  <c:pt idx="24">
                    <c:v>0.37</c:v>
                  </c:pt>
                  <c:pt idx="25">
                    <c:v>0.25000000000000006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" formatCode="0.00">
                  <c:v>1</c:v>
                </c:pt>
                <c:pt idx="3" formatCode="0.00">
                  <c:v>0.97</c:v>
                </c:pt>
                <c:pt idx="4" formatCode="0.00">
                  <c:v>1.05</c:v>
                </c:pt>
                <c:pt idx="5" formatCode="0.00">
                  <c:v>0.87</c:v>
                </c:pt>
                <c:pt idx="7" formatCode="0.00">
                  <c:v>1</c:v>
                </c:pt>
                <c:pt idx="8" formatCode="0.00">
                  <c:v>0.72</c:v>
                </c:pt>
                <c:pt idx="9" formatCode="0.00">
                  <c:v>0.76</c:v>
                </c:pt>
                <c:pt idx="10" formatCode="0.00">
                  <c:v>0.62</c:v>
                </c:pt>
                <c:pt idx="12" formatCode="0.00">
                  <c:v>1</c:v>
                </c:pt>
                <c:pt idx="13" formatCode="0.00">
                  <c:v>1.06</c:v>
                </c:pt>
                <c:pt idx="14" formatCode="0.00">
                  <c:v>0.96</c:v>
                </c:pt>
                <c:pt idx="15" formatCode="0.00">
                  <c:v>0.95</c:v>
                </c:pt>
                <c:pt idx="17" formatCode="0.00">
                  <c:v>1</c:v>
                </c:pt>
                <c:pt idx="18" formatCode="0.00">
                  <c:v>1.1299999999999999</c:v>
                </c:pt>
                <c:pt idx="19" formatCode="0.00">
                  <c:v>1.05</c:v>
                </c:pt>
                <c:pt idx="20" formatCode="0.00">
                  <c:v>1</c:v>
                </c:pt>
                <c:pt idx="22" formatCode="0.00">
                  <c:v>1</c:v>
                </c:pt>
                <c:pt idx="23" formatCode="0.00">
                  <c:v>0.6</c:v>
                </c:pt>
                <c:pt idx="24" formatCode="0.00">
                  <c:v>0.89</c:v>
                </c:pt>
                <c:pt idx="25">
                  <c:v>0.67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">
                  <c:v>49</c:v>
                </c:pt>
                <c:pt idx="2">
                  <c:v>47</c:v>
                </c:pt>
                <c:pt idx="3">
                  <c:v>45</c:v>
                </c:pt>
                <c:pt idx="4">
                  <c:v>43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EE6-4A8D-AF1F-E4F9F16B88FC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EE6-4A8D-AF1F-E4F9F16B88FC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EE6-4A8D-AF1F-E4F9F16B88FC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8EE6-4A8D-AF1F-E4F9F16B88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54080"/>
        <c:axId val="498666048"/>
      </c:scatterChart>
      <c:valAx>
        <c:axId val="498654080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66048"/>
        <c:crosses val="autoZero"/>
        <c:crossBetween val="midCat"/>
        <c:majorUnit val="0.5"/>
      </c:valAx>
      <c:valAx>
        <c:axId val="498666048"/>
        <c:scaling>
          <c:orientation val="minMax"/>
          <c:max val="49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540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0999999999999996</c:v>
                  </c:pt>
                  <c:pt idx="4">
                    <c:v>0.24</c:v>
                  </c:pt>
                  <c:pt idx="5">
                    <c:v>0.17000000000000004</c:v>
                  </c:pt>
                  <c:pt idx="6">
                    <c:v>0</c:v>
                  </c:pt>
                  <c:pt idx="7">
                    <c:v>0</c:v>
                  </c:pt>
                  <c:pt idx="8">
                    <c:v>0.45999999999999996</c:v>
                  </c:pt>
                  <c:pt idx="9">
                    <c:v>0.54999999999999993</c:v>
                  </c:pt>
                  <c:pt idx="10">
                    <c:v>0.37999999999999989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4</c:v>
                  </c:pt>
                  <c:pt idx="14">
                    <c:v>0.25</c:v>
                  </c:pt>
                  <c:pt idx="15">
                    <c:v>0.19999999999999996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3899999999999999</c:v>
                  </c:pt>
                  <c:pt idx="19">
                    <c:v>0.37</c:v>
                  </c:pt>
                  <c:pt idx="20">
                    <c:v>0.30999999999999994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43000000000000005</c:v>
                  </c:pt>
                  <c:pt idx="24">
                    <c:v>0.59</c:v>
                  </c:pt>
                  <c:pt idx="25">
                    <c:v>0.3899999999999999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17999999999999994</c:v>
                  </c:pt>
                  <c:pt idx="4">
                    <c:v>0.20000000000000007</c:v>
                  </c:pt>
                  <c:pt idx="5">
                    <c:v>0.15000000000000002</c:v>
                  </c:pt>
                  <c:pt idx="6">
                    <c:v>0</c:v>
                  </c:pt>
                  <c:pt idx="7">
                    <c:v>0</c:v>
                  </c:pt>
                  <c:pt idx="8">
                    <c:v>0.28999999999999998</c:v>
                  </c:pt>
                  <c:pt idx="9">
                    <c:v>0.33999999999999997</c:v>
                  </c:pt>
                  <c:pt idx="10">
                    <c:v>0.26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0000000000000007</c:v>
                  </c:pt>
                  <c:pt idx="14">
                    <c:v>0.21000000000000008</c:v>
                  </c:pt>
                  <c:pt idx="15">
                    <c:v>0.16999999999999993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28000000000000003</c:v>
                  </c:pt>
                  <c:pt idx="19">
                    <c:v>0.27</c:v>
                  </c:pt>
                  <c:pt idx="20">
                    <c:v>0.23000000000000009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25</c:v>
                  </c:pt>
                  <c:pt idx="24">
                    <c:v>0.3600000000000001</c:v>
                  </c:pt>
                  <c:pt idx="25">
                    <c:v>0.26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" formatCode="0.00">
                  <c:v>1</c:v>
                </c:pt>
                <c:pt idx="3" formatCode="0.00">
                  <c:v>0.99</c:v>
                </c:pt>
                <c:pt idx="4" formatCode="0.00">
                  <c:v>1.06</c:v>
                </c:pt>
                <c:pt idx="5" formatCode="0.00">
                  <c:v>0.91</c:v>
                </c:pt>
                <c:pt idx="7" formatCode="0.00">
                  <c:v>1</c:v>
                </c:pt>
                <c:pt idx="8" formatCode="0.00">
                  <c:v>0.73</c:v>
                </c:pt>
                <c:pt idx="9" formatCode="0.00">
                  <c:v>0.87</c:v>
                </c:pt>
                <c:pt idx="10" formatCode="0.00">
                  <c:v>0.75</c:v>
                </c:pt>
                <c:pt idx="12" formatCode="0.00">
                  <c:v>1</c:v>
                </c:pt>
                <c:pt idx="13" formatCode="0.00">
                  <c:v>1.03</c:v>
                </c:pt>
                <c:pt idx="14" formatCode="0.00">
                  <c:v>1.04</c:v>
                </c:pt>
                <c:pt idx="15" formatCode="0.00">
                  <c:v>0.97</c:v>
                </c:pt>
                <c:pt idx="17" formatCode="0.00">
                  <c:v>1</c:v>
                </c:pt>
                <c:pt idx="18" formatCode="0.00">
                  <c:v>1.01</c:v>
                </c:pt>
                <c:pt idx="19" formatCode="0.00">
                  <c:v>0.92</c:v>
                </c:pt>
                <c:pt idx="20" formatCode="0.00">
                  <c:v>0.93</c:v>
                </c:pt>
                <c:pt idx="22" formatCode="0.00">
                  <c:v>1</c:v>
                </c:pt>
                <c:pt idx="23" formatCode="0.00">
                  <c:v>0.62</c:v>
                </c:pt>
                <c:pt idx="24" formatCode="0.00">
                  <c:v>0.93</c:v>
                </c:pt>
                <c:pt idx="25">
                  <c:v>0.76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">
                  <c:v>49</c:v>
                </c:pt>
                <c:pt idx="2">
                  <c:v>47</c:v>
                </c:pt>
                <c:pt idx="3">
                  <c:v>45</c:v>
                </c:pt>
                <c:pt idx="4">
                  <c:v>43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A8F-40B4-A68E-04F7CABB8CA0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A8F-40B4-A68E-04F7CABB8CA0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A8F-40B4-A68E-04F7CABB8CA0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1A8F-40B4-A68E-04F7CABB8C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62240"/>
        <c:axId val="498657344"/>
      </c:scatterChart>
      <c:valAx>
        <c:axId val="498662240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57344"/>
        <c:crosses val="autoZero"/>
        <c:crossBetween val="midCat"/>
        <c:majorUnit val="0.5"/>
      </c:valAx>
      <c:valAx>
        <c:axId val="498657344"/>
        <c:scaling>
          <c:orientation val="minMax"/>
          <c:max val="49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622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5</c:v>
                  </c:pt>
                  <c:pt idx="4">
                    <c:v>0.27</c:v>
                  </c:pt>
                  <c:pt idx="5">
                    <c:v>0.19000000000000006</c:v>
                  </c:pt>
                  <c:pt idx="6">
                    <c:v>0</c:v>
                  </c:pt>
                  <c:pt idx="7">
                    <c:v>0</c:v>
                  </c:pt>
                  <c:pt idx="8">
                    <c:v>0.54</c:v>
                  </c:pt>
                  <c:pt idx="9">
                    <c:v>0.65</c:v>
                  </c:pt>
                  <c:pt idx="10">
                    <c:v>0.42000000000000015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7</c:v>
                  </c:pt>
                  <c:pt idx="14">
                    <c:v>0.28000000000000003</c:v>
                  </c:pt>
                  <c:pt idx="15">
                    <c:v>0.20999999999999996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45999999999999996</c:v>
                  </c:pt>
                  <c:pt idx="19">
                    <c:v>0.43999999999999995</c:v>
                  </c:pt>
                  <c:pt idx="20">
                    <c:v>0.3600000000000001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47000000000000008</c:v>
                  </c:pt>
                  <c:pt idx="24">
                    <c:v>0.64</c:v>
                  </c:pt>
                  <c:pt idx="25">
                    <c:v>0.39000000000000012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0999999999999996</c:v>
                  </c:pt>
                  <c:pt idx="4">
                    <c:v>0.21000000000000008</c:v>
                  </c:pt>
                  <c:pt idx="5">
                    <c:v>0.15000000000000002</c:v>
                  </c:pt>
                  <c:pt idx="6">
                    <c:v>0</c:v>
                  </c:pt>
                  <c:pt idx="7">
                    <c:v>0</c:v>
                  </c:pt>
                  <c:pt idx="8">
                    <c:v>0.32</c:v>
                  </c:pt>
                  <c:pt idx="9">
                    <c:v>0.37</c:v>
                  </c:pt>
                  <c:pt idx="10">
                    <c:v>0.26999999999999996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1000000000000008</c:v>
                  </c:pt>
                  <c:pt idx="14">
                    <c:v>0.21999999999999997</c:v>
                  </c:pt>
                  <c:pt idx="15">
                    <c:v>0.16999999999999993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33000000000000007</c:v>
                  </c:pt>
                  <c:pt idx="19">
                    <c:v>0.29999999999999993</c:v>
                  </c:pt>
                  <c:pt idx="20">
                    <c:v>0.27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27</c:v>
                  </c:pt>
                  <c:pt idx="24">
                    <c:v>0.37</c:v>
                  </c:pt>
                  <c:pt idx="25">
                    <c:v>0.25999999999999995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" formatCode="0.00">
                  <c:v>1</c:v>
                </c:pt>
                <c:pt idx="3" formatCode="0.00">
                  <c:v>1.02</c:v>
                </c:pt>
                <c:pt idx="4" formatCode="0.00">
                  <c:v>1.08</c:v>
                </c:pt>
                <c:pt idx="5" formatCode="0.00">
                  <c:v>0.88</c:v>
                </c:pt>
                <c:pt idx="7" formatCode="0.00">
                  <c:v>1</c:v>
                </c:pt>
                <c:pt idx="8" formatCode="0.00">
                  <c:v>0.77</c:v>
                </c:pt>
                <c:pt idx="9" formatCode="0.00">
                  <c:v>0.88</c:v>
                </c:pt>
                <c:pt idx="10" formatCode="0.00">
                  <c:v>0.7</c:v>
                </c:pt>
                <c:pt idx="12" formatCode="0.00">
                  <c:v>1</c:v>
                </c:pt>
                <c:pt idx="13" formatCode="0.00">
                  <c:v>1.03</c:v>
                </c:pt>
                <c:pt idx="14" formatCode="0.00">
                  <c:v>1.03</c:v>
                </c:pt>
                <c:pt idx="15" formatCode="0.00">
                  <c:v>0.96</c:v>
                </c:pt>
                <c:pt idx="17" formatCode="0.00">
                  <c:v>1</c:v>
                </c:pt>
                <c:pt idx="18" formatCode="0.00">
                  <c:v>1.1000000000000001</c:v>
                </c:pt>
                <c:pt idx="19" formatCode="0.00">
                  <c:v>0.96</c:v>
                </c:pt>
                <c:pt idx="20" formatCode="0.00">
                  <c:v>0.98</c:v>
                </c:pt>
                <c:pt idx="22" formatCode="0.00">
                  <c:v>1</c:v>
                </c:pt>
                <c:pt idx="23" formatCode="0.00">
                  <c:v>0.63</c:v>
                </c:pt>
                <c:pt idx="24" formatCode="0.00">
                  <c:v>0.9</c:v>
                </c:pt>
                <c:pt idx="25">
                  <c:v>0.7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">
                  <c:v>49</c:v>
                </c:pt>
                <c:pt idx="2">
                  <c:v>47</c:v>
                </c:pt>
                <c:pt idx="3">
                  <c:v>45</c:v>
                </c:pt>
                <c:pt idx="4">
                  <c:v>43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149-4924-AECA-BD26285DE9B2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149-4924-AECA-BD26285DE9B2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149-4924-AECA-BD26285DE9B2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149-4924-AECA-BD26285DE9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54624"/>
        <c:axId val="498662784"/>
      </c:scatterChart>
      <c:valAx>
        <c:axId val="498654624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62784"/>
        <c:crosses val="autoZero"/>
        <c:crossBetween val="midCat"/>
        <c:majorUnit val="0.5"/>
      </c:valAx>
      <c:valAx>
        <c:axId val="498662784"/>
        <c:scaling>
          <c:orientation val="minMax"/>
          <c:max val="49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546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1">
                    <c:v>0</c:v>
                  </c:pt>
                  <c:pt idx="22">
                    <c:v>0</c:v>
                  </c:pt>
                  <c:pt idx="23">
                    <c:v>1.1499999999999999</c:v>
                  </c:pt>
                  <c:pt idx="24">
                    <c:v>1.1299999999999999</c:v>
                  </c:pt>
                  <c:pt idx="25">
                    <c:v>0.88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1">
                    <c:v>0</c:v>
                  </c:pt>
                  <c:pt idx="22">
                    <c:v>0</c:v>
                  </c:pt>
                  <c:pt idx="23">
                    <c:v>0.5</c:v>
                  </c:pt>
                  <c:pt idx="24">
                    <c:v>0.47000000000000003</c:v>
                  </c:pt>
                  <c:pt idx="25">
                    <c:v>0.44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2" formatCode="0.00">
                  <c:v>1</c:v>
                </c:pt>
                <c:pt idx="23" formatCode="0.00">
                  <c:v>0.89</c:v>
                </c:pt>
                <c:pt idx="24" formatCode="0.00">
                  <c:v>0.81</c:v>
                </c:pt>
                <c:pt idx="25">
                  <c:v>0.87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D7A-4A9F-8377-AE6A881A091A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D7A-4A9F-8377-AE6A881A091A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D7A-4A9F-8377-AE6A881A091A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D7A-4A9F-8377-AE6A881A09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64960"/>
        <c:axId val="498659520"/>
      </c:scatterChart>
      <c:valAx>
        <c:axId val="498664960"/>
        <c:scaling>
          <c:orientation val="minMax"/>
          <c:max val="2.5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59520"/>
        <c:crosses val="autoZero"/>
        <c:crossBetween val="midCat"/>
        <c:majorUnit val="0.5"/>
      </c:valAx>
      <c:valAx>
        <c:axId val="498659520"/>
        <c:scaling>
          <c:orientation val="minMax"/>
          <c:max val="8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649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38000000000000012</c:v>
                  </c:pt>
                  <c:pt idx="4">
                    <c:v>0.45999999999999996</c:v>
                  </c:pt>
                  <c:pt idx="5">
                    <c:v>0.25</c:v>
                  </c:pt>
                  <c:pt idx="6">
                    <c:v>0</c:v>
                  </c:pt>
                  <c:pt idx="7">
                    <c:v>0</c:v>
                  </c:pt>
                  <c:pt idx="8">
                    <c:v>1.0699999999999998</c:v>
                  </c:pt>
                  <c:pt idx="9">
                    <c:v>1.1599999999999997</c:v>
                  </c:pt>
                  <c:pt idx="10">
                    <c:v>0.5800000000000000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5</c:v>
                  </c:pt>
                  <c:pt idx="14">
                    <c:v>0.43999999999999995</c:v>
                  </c:pt>
                  <c:pt idx="15">
                    <c:v>0.31999999999999995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99000000000000021</c:v>
                  </c:pt>
                  <c:pt idx="19">
                    <c:v>0.81</c:v>
                  </c:pt>
                  <c:pt idx="20">
                    <c:v>0.62999999999999989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73</c:v>
                  </c:pt>
                  <c:pt idx="24">
                    <c:v>1.58</c:v>
                  </c:pt>
                  <c:pt idx="25">
                    <c:v>0.74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7</c:v>
                  </c:pt>
                  <c:pt idx="4">
                    <c:v>0.47</c:v>
                  </c:pt>
                  <c:pt idx="5">
                    <c:v>0.20000000000000007</c:v>
                  </c:pt>
                  <c:pt idx="6">
                    <c:v>0</c:v>
                  </c:pt>
                  <c:pt idx="7">
                    <c:v>0</c:v>
                  </c:pt>
                  <c:pt idx="8">
                    <c:v>0.5</c:v>
                  </c:pt>
                  <c:pt idx="9">
                    <c:v>0.51</c:v>
                  </c:pt>
                  <c:pt idx="10">
                    <c:v>0.27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35</c:v>
                  </c:pt>
                  <c:pt idx="14">
                    <c:v>0.28999999999999992</c:v>
                  </c:pt>
                  <c:pt idx="15">
                    <c:v>0.22999999999999998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57999999999999996</c:v>
                  </c:pt>
                  <c:pt idx="19">
                    <c:v>0.46000000000000008</c:v>
                  </c:pt>
                  <c:pt idx="20">
                    <c:v>0.39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27</c:v>
                  </c:pt>
                  <c:pt idx="24">
                    <c:v>0.72999999999999987</c:v>
                  </c:pt>
                  <c:pt idx="25">
                    <c:v>0.3599999999999999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" formatCode="0.00">
                  <c:v>1</c:v>
                </c:pt>
                <c:pt idx="3" formatCode="0.00">
                  <c:v>0.99</c:v>
                </c:pt>
                <c:pt idx="4" formatCode="0.00">
                  <c:v>1.19</c:v>
                </c:pt>
                <c:pt idx="5" formatCode="0.00">
                  <c:v>0.77</c:v>
                </c:pt>
                <c:pt idx="7" formatCode="0.00">
                  <c:v>1</c:v>
                </c:pt>
                <c:pt idx="8" formatCode="0.00">
                  <c:v>0.92</c:v>
                </c:pt>
                <c:pt idx="9" formatCode="0.00">
                  <c:v>0.91</c:v>
                </c:pt>
                <c:pt idx="10" formatCode="0.00">
                  <c:v>0.53</c:v>
                </c:pt>
                <c:pt idx="12" formatCode="0.00">
                  <c:v>1</c:v>
                </c:pt>
                <c:pt idx="13" formatCode="0.00">
                  <c:v>1.22</c:v>
                </c:pt>
                <c:pt idx="14" formatCode="0.00">
                  <c:v>0.94</c:v>
                </c:pt>
                <c:pt idx="15" formatCode="0.00">
                  <c:v>0.86</c:v>
                </c:pt>
                <c:pt idx="17" formatCode="0.00">
                  <c:v>1</c:v>
                </c:pt>
                <c:pt idx="18" formatCode="0.00">
                  <c:v>1.42</c:v>
                </c:pt>
                <c:pt idx="19" formatCode="0.00">
                  <c:v>1.05</c:v>
                </c:pt>
                <c:pt idx="20" formatCode="0.00">
                  <c:v>1.02</c:v>
                </c:pt>
                <c:pt idx="22" formatCode="0.00">
                  <c:v>1</c:v>
                </c:pt>
                <c:pt idx="23" formatCode="0.00">
                  <c:v>0.43</c:v>
                </c:pt>
                <c:pt idx="24" formatCode="0.00">
                  <c:v>1.38</c:v>
                </c:pt>
                <c:pt idx="25">
                  <c:v>0.7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">
                  <c:v>49</c:v>
                </c:pt>
                <c:pt idx="2">
                  <c:v>47</c:v>
                </c:pt>
                <c:pt idx="3">
                  <c:v>45</c:v>
                </c:pt>
                <c:pt idx="4">
                  <c:v>43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DF6-4755-AA02-63F5C967A681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DF6-4755-AA02-63F5C967A681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DF6-4755-AA02-63F5C967A681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DF6-4755-AA02-63F5C967A6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67680"/>
        <c:axId val="498666592"/>
      </c:scatterChart>
      <c:valAx>
        <c:axId val="498667680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66592"/>
        <c:crosses val="autoZero"/>
        <c:crossBetween val="midCat"/>
        <c:majorUnit val="0.5"/>
      </c:valAx>
      <c:valAx>
        <c:axId val="498666592"/>
        <c:scaling>
          <c:orientation val="minMax"/>
          <c:max val="49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676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8000000000000003</c:v>
                  </c:pt>
                  <c:pt idx="4">
                    <c:v>0.30000000000000004</c:v>
                  </c:pt>
                  <c:pt idx="5">
                    <c:v>0.20999999999999985</c:v>
                  </c:pt>
                  <c:pt idx="6">
                    <c:v>0</c:v>
                  </c:pt>
                  <c:pt idx="7">
                    <c:v>0</c:v>
                  </c:pt>
                  <c:pt idx="8">
                    <c:v>0.54</c:v>
                  </c:pt>
                  <c:pt idx="9">
                    <c:v>0.67</c:v>
                  </c:pt>
                  <c:pt idx="10">
                    <c:v>0.41000000000000003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30999999999999983</c:v>
                  </c:pt>
                  <c:pt idx="14">
                    <c:v>0.31000000000000005</c:v>
                  </c:pt>
                  <c:pt idx="15">
                    <c:v>0.26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60999999999999988</c:v>
                  </c:pt>
                  <c:pt idx="19">
                    <c:v>0.56000000000000005</c:v>
                  </c:pt>
                  <c:pt idx="20">
                    <c:v>0.45999999999999996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60000000000000009</c:v>
                  </c:pt>
                  <c:pt idx="24">
                    <c:v>0.8</c:v>
                  </c:pt>
                  <c:pt idx="25">
                    <c:v>0.51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2">
                    <c:v>0</c:v>
                  </c:pt>
                  <c:pt idx="3">
                    <c:v>0.23000000000000009</c:v>
                  </c:pt>
                  <c:pt idx="4">
                    <c:v>0.23000000000000009</c:v>
                  </c:pt>
                  <c:pt idx="5">
                    <c:v>0.17000000000000004</c:v>
                  </c:pt>
                  <c:pt idx="6">
                    <c:v>0</c:v>
                  </c:pt>
                  <c:pt idx="7">
                    <c:v>0</c:v>
                  </c:pt>
                  <c:pt idx="8">
                    <c:v>0.31</c:v>
                  </c:pt>
                  <c:pt idx="9">
                    <c:v>0.38</c:v>
                  </c:pt>
                  <c:pt idx="10">
                    <c:v>0.26</c:v>
                  </c:pt>
                  <c:pt idx="11">
                    <c:v>0</c:v>
                  </c:pt>
                  <c:pt idx="12">
                    <c:v>0</c:v>
                  </c:pt>
                  <c:pt idx="13">
                    <c:v>0.25000000000000011</c:v>
                  </c:pt>
                  <c:pt idx="14">
                    <c:v>0.2400000000000001</c:v>
                  </c:pt>
                  <c:pt idx="15">
                    <c:v>0.20000000000000007</c:v>
                  </c:pt>
                  <c:pt idx="16">
                    <c:v>0</c:v>
                  </c:pt>
                  <c:pt idx="17">
                    <c:v>0</c:v>
                  </c:pt>
                  <c:pt idx="18">
                    <c:v>0.42000000000000004</c:v>
                  </c:pt>
                  <c:pt idx="19">
                    <c:v>0.37999999999999989</c:v>
                  </c:pt>
                  <c:pt idx="20">
                    <c:v>0.32000000000000006</c:v>
                  </c:pt>
                  <c:pt idx="21">
                    <c:v>0</c:v>
                  </c:pt>
                  <c:pt idx="22">
                    <c:v>0</c:v>
                  </c:pt>
                  <c:pt idx="23">
                    <c:v>0.32999999999999996</c:v>
                  </c:pt>
                  <c:pt idx="24">
                    <c:v>0.45000000000000007</c:v>
                  </c:pt>
                  <c:pt idx="25">
                    <c:v>0.31000000000000005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2" formatCode="0.00">
                  <c:v>1</c:v>
                </c:pt>
                <c:pt idx="3" formatCode="0.00">
                  <c:v>1.06</c:v>
                </c:pt>
                <c:pt idx="4" formatCode="0.00">
                  <c:v>1.06</c:v>
                </c:pt>
                <c:pt idx="5" formatCode="0.00">
                  <c:v>0.92</c:v>
                </c:pt>
                <c:pt idx="7" formatCode="0.00">
                  <c:v>1</c:v>
                </c:pt>
                <c:pt idx="8" formatCode="0.00">
                  <c:v>0.72</c:v>
                </c:pt>
                <c:pt idx="9" formatCode="0.00">
                  <c:v>0.9</c:v>
                </c:pt>
                <c:pt idx="10" formatCode="0.00">
                  <c:v>0.66</c:v>
                </c:pt>
                <c:pt idx="12" formatCode="0.00">
                  <c:v>1</c:v>
                </c:pt>
                <c:pt idx="13" formatCode="0.00">
                  <c:v>1.1000000000000001</c:v>
                </c:pt>
                <c:pt idx="14" formatCode="0.00">
                  <c:v>1.06</c:v>
                </c:pt>
                <c:pt idx="15" formatCode="0.00">
                  <c:v>1.03</c:v>
                </c:pt>
                <c:pt idx="17" formatCode="0.00">
                  <c:v>1</c:v>
                </c:pt>
                <c:pt idx="18" formatCode="0.00">
                  <c:v>1.3</c:v>
                </c:pt>
                <c:pt idx="19" formatCode="0.00">
                  <c:v>1.1299999999999999</c:v>
                </c:pt>
                <c:pt idx="20" formatCode="0.00">
                  <c:v>1.1000000000000001</c:v>
                </c:pt>
                <c:pt idx="22" formatCode="0.00">
                  <c:v>1</c:v>
                </c:pt>
                <c:pt idx="23" formatCode="0.00">
                  <c:v>0.73</c:v>
                </c:pt>
                <c:pt idx="24" formatCode="0.00">
                  <c:v>1.04</c:v>
                </c:pt>
                <c:pt idx="25">
                  <c:v>0.78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">
                  <c:v>49</c:v>
                </c:pt>
                <c:pt idx="2">
                  <c:v>47</c:v>
                </c:pt>
                <c:pt idx="3">
                  <c:v>45</c:v>
                </c:pt>
                <c:pt idx="4">
                  <c:v>43</c:v>
                </c:pt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7B8-4EC3-A2F0-EDD9247E9B09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7B8-4EC3-A2F0-EDD9247E9B09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7B8-4EC3-A2F0-EDD9247E9B09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2">
                  <c:v>49</c:v>
                </c:pt>
                <c:pt idx="3">
                  <c:v>47</c:v>
                </c:pt>
                <c:pt idx="4">
                  <c:v>45</c:v>
                </c:pt>
                <c:pt idx="5">
                  <c:v>43</c:v>
                </c:pt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07B8-4EC3-A2F0-EDD9247E9B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67136"/>
        <c:axId val="498668224"/>
      </c:scatterChart>
      <c:valAx>
        <c:axId val="498667136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8668224"/>
        <c:crosses val="autoZero"/>
        <c:crossBetween val="midCat"/>
        <c:majorUnit val="0.5"/>
      </c:valAx>
      <c:valAx>
        <c:axId val="498668224"/>
        <c:scaling>
          <c:orientation val="minMax"/>
          <c:max val="49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671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5">
                    <c:v>0</c:v>
                  </c:pt>
                  <c:pt idx="6">
                    <c:v>0</c:v>
                  </c:pt>
                  <c:pt idx="7">
                    <c:v>0.25</c:v>
                  </c:pt>
                  <c:pt idx="8">
                    <c:v>0.27</c:v>
                  </c:pt>
                  <c:pt idx="9">
                    <c:v>0.22999999999999987</c:v>
                  </c:pt>
                  <c:pt idx="10">
                    <c:v>0.2400000000000001</c:v>
                  </c:pt>
                  <c:pt idx="11">
                    <c:v>0.27000000000000013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55000000000000004</c:v>
                  </c:pt>
                  <c:pt idx="15">
                    <c:v>0.64</c:v>
                  </c:pt>
                  <c:pt idx="16">
                    <c:v>0.46000000000000008</c:v>
                  </c:pt>
                  <c:pt idx="17">
                    <c:v>0.60999999999999988</c:v>
                  </c:pt>
                  <c:pt idx="18">
                    <c:v>0.67999999999999994</c:v>
                  </c:pt>
                  <c:pt idx="19">
                    <c:v>0</c:v>
                  </c:pt>
                  <c:pt idx="20">
                    <c:v>0</c:v>
                  </c:pt>
                  <c:pt idx="21">
                    <c:v>0.27</c:v>
                  </c:pt>
                  <c:pt idx="22">
                    <c:v>0.27</c:v>
                  </c:pt>
                  <c:pt idx="23">
                    <c:v>0.24</c:v>
                  </c:pt>
                  <c:pt idx="24">
                    <c:v>0.27</c:v>
                  </c:pt>
                  <c:pt idx="25">
                    <c:v>0.32000000000000006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5">
                    <c:v>0</c:v>
                  </c:pt>
                  <c:pt idx="6">
                    <c:v>0</c:v>
                  </c:pt>
                  <c:pt idx="7">
                    <c:v>0.20000000000000007</c:v>
                  </c:pt>
                  <c:pt idx="8">
                    <c:v>0.21000000000000008</c:v>
                  </c:pt>
                  <c:pt idx="9">
                    <c:v>0.18000000000000005</c:v>
                  </c:pt>
                  <c:pt idx="10">
                    <c:v>0.18999999999999995</c:v>
                  </c:pt>
                  <c:pt idx="11">
                    <c:v>0.20999999999999996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32</c:v>
                  </c:pt>
                  <c:pt idx="15">
                    <c:v>0.37</c:v>
                  </c:pt>
                  <c:pt idx="16">
                    <c:v>0.27</c:v>
                  </c:pt>
                  <c:pt idx="17">
                    <c:v>0.35000000000000003</c:v>
                  </c:pt>
                  <c:pt idx="18">
                    <c:v>0.35</c:v>
                  </c:pt>
                  <c:pt idx="19">
                    <c:v>0</c:v>
                  </c:pt>
                  <c:pt idx="20">
                    <c:v>0</c:v>
                  </c:pt>
                  <c:pt idx="21">
                    <c:v>0.21000000000000008</c:v>
                  </c:pt>
                  <c:pt idx="22">
                    <c:v>0.21999999999999997</c:v>
                  </c:pt>
                  <c:pt idx="23">
                    <c:v>0.18999999999999995</c:v>
                  </c:pt>
                  <c:pt idx="24">
                    <c:v>0.21999999999999997</c:v>
                  </c:pt>
                  <c:pt idx="25">
                    <c:v>0.24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6" formatCode="0.00">
                  <c:v>1</c:v>
                </c:pt>
                <c:pt idx="7" formatCode="0.00">
                  <c:v>1.02</c:v>
                </c:pt>
                <c:pt idx="8" formatCode="0.00">
                  <c:v>1.08</c:v>
                </c:pt>
                <c:pt idx="9" formatCode="0.00">
                  <c:v>0.92</c:v>
                </c:pt>
                <c:pt idx="10" formatCode="0.00">
                  <c:v>0.86</c:v>
                </c:pt>
                <c:pt idx="11" formatCode="0.00">
                  <c:v>0.83</c:v>
                </c:pt>
                <c:pt idx="13" formatCode="0.00">
                  <c:v>1</c:v>
                </c:pt>
                <c:pt idx="14" formatCode="0.00">
                  <c:v>0.77</c:v>
                </c:pt>
                <c:pt idx="15" formatCode="0.00">
                  <c:v>0.88</c:v>
                </c:pt>
                <c:pt idx="16" formatCode="0.00">
                  <c:v>0.65</c:v>
                </c:pt>
                <c:pt idx="17" formatCode="0.00">
                  <c:v>0.78</c:v>
                </c:pt>
                <c:pt idx="18" formatCode="0.00">
                  <c:v>0.7</c:v>
                </c:pt>
                <c:pt idx="20" formatCode="0.00">
                  <c:v>1</c:v>
                </c:pt>
                <c:pt idx="21" formatCode="0.00">
                  <c:v>1.03</c:v>
                </c:pt>
                <c:pt idx="22" formatCode="0.00">
                  <c:v>1.03</c:v>
                </c:pt>
                <c:pt idx="23" formatCode="0.00">
                  <c:v>0.95</c:v>
                </c:pt>
                <c:pt idx="24" formatCode="0.00">
                  <c:v>0.95</c:v>
                </c:pt>
                <c:pt idx="25">
                  <c:v>1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5">
                  <c:v>41</c:v>
                </c:pt>
                <c:pt idx="6">
                  <c:v>39</c:v>
                </c:pt>
                <c:pt idx="7">
                  <c:v>37</c:v>
                </c:pt>
                <c:pt idx="8">
                  <c:v>35</c:v>
                </c:pt>
                <c:pt idx="9">
                  <c:v>33</c:v>
                </c:pt>
                <c:pt idx="10">
                  <c:v>31</c:v>
                </c:pt>
                <c:pt idx="11">
                  <c:v>29</c:v>
                </c:pt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A69-4FC3-93CA-AF12FD4A617F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A69-4FC3-93CA-AF12FD4A617F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A69-4FC3-93CA-AF12FD4A617F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6">
                  <c:v>41</c:v>
                </c:pt>
                <c:pt idx="7">
                  <c:v>39</c:v>
                </c:pt>
                <c:pt idx="8">
                  <c:v>37</c:v>
                </c:pt>
                <c:pt idx="9">
                  <c:v>35</c:v>
                </c:pt>
                <c:pt idx="10">
                  <c:v>33</c:v>
                </c:pt>
                <c:pt idx="11">
                  <c:v>31</c:v>
                </c:pt>
                <c:pt idx="12">
                  <c:v>29</c:v>
                </c:pt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A69-4FC3-93CA-AF12FD4A61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8655712"/>
        <c:axId val="411124960"/>
      </c:scatterChart>
      <c:valAx>
        <c:axId val="498655712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1124960"/>
        <c:crosses val="autoZero"/>
        <c:crossBetween val="midCat"/>
        <c:majorUnit val="0.5"/>
      </c:valAx>
      <c:valAx>
        <c:axId val="411124960"/>
        <c:scaling>
          <c:orientation val="minMax"/>
          <c:max val="41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4986557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スライド２!$C$3</c:f>
              <c:strCache>
                <c:ptCount val="1"/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cust"/>
            <c:noEndCap val="0"/>
            <c:plus>
              <c:numRef>
                <c:f>スライド２!$H$4:$H$29</c:f>
                <c:numCache>
                  <c:formatCode>General</c:formatCode>
                  <c:ptCount val="26"/>
                  <c:pt idx="12">
                    <c:v>0</c:v>
                  </c:pt>
                  <c:pt idx="13">
                    <c:v>0</c:v>
                  </c:pt>
                  <c:pt idx="14">
                    <c:v>0.47</c:v>
                  </c:pt>
                  <c:pt idx="15">
                    <c:v>0.42999999999999994</c:v>
                  </c:pt>
                  <c:pt idx="16">
                    <c:v>0.43999999999999995</c:v>
                  </c:pt>
                  <c:pt idx="17">
                    <c:v>0.44000000000000006</c:v>
                  </c:pt>
                  <c:pt idx="18">
                    <c:v>0.5099999999999999</c:v>
                  </c:pt>
                  <c:pt idx="19">
                    <c:v>0</c:v>
                  </c:pt>
                  <c:pt idx="20">
                    <c:v>0</c:v>
                  </c:pt>
                  <c:pt idx="21">
                    <c:v>0.47000000000000008</c:v>
                  </c:pt>
                  <c:pt idx="22">
                    <c:v>0.63</c:v>
                  </c:pt>
                  <c:pt idx="23">
                    <c:v>0.45000000000000007</c:v>
                  </c:pt>
                  <c:pt idx="24">
                    <c:v>0.7</c:v>
                  </c:pt>
                  <c:pt idx="25">
                    <c:v>0.56000000000000005</c:v>
                  </c:pt>
                </c:numCache>
              </c:numRef>
            </c:plus>
            <c:minus>
              <c:numRef>
                <c:f>スライド２!$G$4:$G$29</c:f>
                <c:numCache>
                  <c:formatCode>General</c:formatCode>
                  <c:ptCount val="26"/>
                  <c:pt idx="12">
                    <c:v>0</c:v>
                  </c:pt>
                  <c:pt idx="13">
                    <c:v>0</c:v>
                  </c:pt>
                  <c:pt idx="14">
                    <c:v>0.33000000000000007</c:v>
                  </c:pt>
                  <c:pt idx="15">
                    <c:v>0.30999999999999994</c:v>
                  </c:pt>
                  <c:pt idx="16">
                    <c:v>0.31000000000000005</c:v>
                  </c:pt>
                  <c:pt idx="17">
                    <c:v>0.29000000000000004</c:v>
                  </c:pt>
                  <c:pt idx="18">
                    <c:v>0.32000000000000006</c:v>
                  </c:pt>
                  <c:pt idx="19">
                    <c:v>0</c:v>
                  </c:pt>
                  <c:pt idx="20">
                    <c:v>0</c:v>
                  </c:pt>
                  <c:pt idx="21">
                    <c:v>0.27</c:v>
                  </c:pt>
                  <c:pt idx="22">
                    <c:v>0.36</c:v>
                  </c:pt>
                  <c:pt idx="23">
                    <c:v>0.25</c:v>
                  </c:pt>
                  <c:pt idx="24">
                    <c:v>0.41000000000000003</c:v>
                  </c:pt>
                  <c:pt idx="25">
                    <c:v>0.25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スライド２!$B$4:$B$30</c:f>
              <c:numCache>
                <c:formatCode>General</c:formatCode>
                <c:ptCount val="27"/>
                <c:pt idx="13" formatCode="0.00">
                  <c:v>1</c:v>
                </c:pt>
                <c:pt idx="14" formatCode="0.00">
                  <c:v>1.1000000000000001</c:v>
                </c:pt>
                <c:pt idx="15" formatCode="0.00">
                  <c:v>0.97</c:v>
                </c:pt>
                <c:pt idx="16" formatCode="0.00">
                  <c:v>1.07</c:v>
                </c:pt>
                <c:pt idx="17" formatCode="0.00">
                  <c:v>0.88</c:v>
                </c:pt>
                <c:pt idx="18" formatCode="0.00">
                  <c:v>0.89</c:v>
                </c:pt>
                <c:pt idx="20" formatCode="0.00">
                  <c:v>1</c:v>
                </c:pt>
                <c:pt idx="21" formatCode="0.00">
                  <c:v>0.63</c:v>
                </c:pt>
                <c:pt idx="22" formatCode="0.00">
                  <c:v>0.9</c:v>
                </c:pt>
                <c:pt idx="23" formatCode="0.00">
                  <c:v>0.62</c:v>
                </c:pt>
                <c:pt idx="24" formatCode="0.00">
                  <c:v>0.98</c:v>
                </c:pt>
                <c:pt idx="25">
                  <c:v>0.46</c:v>
                </c:pt>
              </c:numCache>
            </c:numRef>
          </c:xVal>
          <c:yVal>
            <c:numRef>
              <c:f>スライド２!$C$4:$C$30</c:f>
              <c:numCache>
                <c:formatCode>General</c:formatCode>
                <c:ptCount val="27"/>
                <c:pt idx="12">
                  <c:v>27</c:v>
                </c:pt>
                <c:pt idx="13">
                  <c:v>25</c:v>
                </c:pt>
                <c:pt idx="14">
                  <c:v>23</c:v>
                </c:pt>
                <c:pt idx="15">
                  <c:v>21</c:v>
                </c:pt>
                <c:pt idx="16">
                  <c:v>19</c:v>
                </c:pt>
                <c:pt idx="17">
                  <c:v>17</c:v>
                </c:pt>
                <c:pt idx="18">
                  <c:v>15</c:v>
                </c:pt>
                <c:pt idx="19">
                  <c:v>13</c:v>
                </c:pt>
                <c:pt idx="20">
                  <c:v>11</c:v>
                </c:pt>
                <c:pt idx="21">
                  <c:v>9</c:v>
                </c:pt>
                <c:pt idx="22">
                  <c:v>7</c:v>
                </c:pt>
                <c:pt idx="23">
                  <c:v>5</c:v>
                </c:pt>
                <c:pt idx="24">
                  <c:v>3</c:v>
                </c:pt>
                <c:pt idx="25">
                  <c:v>1</c:v>
                </c:pt>
                <c:pt idx="26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16F-4B0D-A2A6-94180C037FAC}"/>
            </c:ext>
          </c:extLst>
        </c:ser>
        <c:ser>
          <c:idx val="1"/>
          <c:order val="1"/>
          <c:spPr>
            <a:ln w="15875" cap="rnd">
              <a:solidFill>
                <a:schemeClr val="tx1">
                  <a:lumMod val="65000"/>
                  <a:lumOff val="3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F$3:$F$30</c:f>
              <c:numCache>
                <c:formatCode>General</c:formatCode>
                <c:ptCount val="28"/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16F-4B0D-A2A6-94180C037FAC}"/>
            </c:ext>
          </c:extLst>
        </c:ser>
        <c:ser>
          <c:idx val="2"/>
          <c:order val="2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I$3:$I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16F-4B0D-A2A6-94180C037FAC}"/>
            </c:ext>
          </c:extLst>
        </c:ser>
        <c:ser>
          <c:idx val="3"/>
          <c:order val="3"/>
          <c:spPr>
            <a:ln w="15875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スライド２!$J$3:$J$30</c:f>
              <c:numCache>
                <c:formatCode>General</c:formatCode>
                <c:ptCount val="28"/>
              </c:numCache>
            </c:numRef>
          </c:xVal>
          <c:yVal>
            <c:numRef>
              <c:f>スライド２!$C$3:$C$30</c:f>
              <c:numCache>
                <c:formatCode>General</c:formatCode>
                <c:ptCount val="28"/>
                <c:pt idx="13">
                  <c:v>27</c:v>
                </c:pt>
                <c:pt idx="14">
                  <c:v>25</c:v>
                </c:pt>
                <c:pt idx="15">
                  <c:v>23</c:v>
                </c:pt>
                <c:pt idx="16">
                  <c:v>21</c:v>
                </c:pt>
                <c:pt idx="17">
                  <c:v>19</c:v>
                </c:pt>
                <c:pt idx="18">
                  <c:v>17</c:v>
                </c:pt>
                <c:pt idx="19">
                  <c:v>15</c:v>
                </c:pt>
                <c:pt idx="20">
                  <c:v>13</c:v>
                </c:pt>
                <c:pt idx="21">
                  <c:v>11</c:v>
                </c:pt>
                <c:pt idx="22">
                  <c:v>9</c:v>
                </c:pt>
                <c:pt idx="23">
                  <c:v>7</c:v>
                </c:pt>
                <c:pt idx="24">
                  <c:v>5</c:v>
                </c:pt>
                <c:pt idx="25">
                  <c:v>3</c:v>
                </c:pt>
                <c:pt idx="26">
                  <c:v>1</c:v>
                </c:pt>
                <c:pt idx="27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16F-4B0D-A2A6-94180C037F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0261376"/>
        <c:axId val="660268448"/>
      </c:scatterChart>
      <c:valAx>
        <c:axId val="660261376"/>
        <c:scaling>
          <c:orientation val="minMax"/>
          <c:max val="2"/>
          <c:min val="0"/>
        </c:scaling>
        <c:delete val="0"/>
        <c:axPos val="b"/>
        <c:numFmt formatCode="#,##0.0_);[Red]\(#,##0.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0268448"/>
        <c:crosses val="autoZero"/>
        <c:crossBetween val="midCat"/>
        <c:majorUnit val="0.5"/>
      </c:valAx>
      <c:valAx>
        <c:axId val="660268448"/>
        <c:scaling>
          <c:orientation val="minMax"/>
          <c:max val="27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6602613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BB09A2C-0BE5-4291-AC3C-F4BAEDD89E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C0FEA7FD-7718-42F7-81D6-71A065C306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2CAFE2E-63A0-4596-B0AE-5CE6A25F1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A9F5C51-0A9D-4C92-864C-6D57E67FB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5178CB5-B11C-412B-91E5-DF265354A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627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6845964-044D-4EFE-B14C-5F1EE2C3A1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29FEB9C6-8737-4AE4-A0B2-45031E40E5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8719C17-FA52-49F4-8B4B-B990B5D32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790BE24-9753-493A-9A7C-F359DA066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09E2BA4-952E-4C49-943A-31793BAC4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669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3DC8B572-B3E5-45CB-A7C6-56FA09B441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42D30A34-C2E8-4E18-A94F-32A1DB6933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314C0E0-1796-4004-B875-933E83E73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C4666479-A81E-48B5-98B9-EC7DC6EF7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5EE1A39-94A2-456B-9487-979437A44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7573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AF1616E-6193-4409-8E8C-80A8CD6F8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83908C01-956D-41DB-8BCC-41D6D85893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1B60682-B5FD-4E53-AF2A-AABBF77B8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BA8BA2C-7ACE-4EBF-A8CC-6BF398213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D3F46A42-1B9D-48EA-90CF-BA6CB31D9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114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A07C839-FE68-47A1-94FC-349A2206E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16B3390-EC89-49DC-B51C-B333E8303E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9174F673-1488-494C-A8B5-E7AD9A509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8CFA1C9-ECAD-490B-A1B8-F7D84635B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B4B9582-490C-4EFC-9F48-4D8C705B99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132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71A918C-8DA5-44E5-8534-077E635FA1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61CC134F-728F-4ADA-80B2-BD53D376D2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90E35DC9-A914-4ACF-8BAD-86B6D63096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09931C7-09AF-4ECF-B338-8822DD118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7B71C65-F016-4912-9F89-CBF4EDF8B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E39AB45-B4DB-4F9B-A4A8-9E93B7832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589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5997F77-FA8C-4C4A-9C14-BE95A3C05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CBB041C1-6F2D-48C6-9E36-542B97DF95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F5A561EA-FDAB-4C0B-883A-7279B5047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EF0BCABF-4DA8-4688-9E1C-D9C9BCEAAA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9FB7AFE7-CD35-4AE3-B47F-D8A3EC7C80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B5727EC2-B7ED-44EB-86A6-FF1A07E03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7DC6A014-09E1-48BD-8802-B773399BE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CADAFCC2-DA59-4462-9C0C-FA64A351F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791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75E2EB6-43B1-4AF6-A0B2-3096859BA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6C4C11C6-0C8E-4F06-9AAD-6E3CC824C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1856F989-03A3-4E3A-9774-CC83C719F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237BA3E3-A3EA-4145-B425-27857FFC6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106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9B593B83-A678-453D-989C-48CAE94FF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78AED767-7641-4878-8182-0938B1683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CF29A25E-772C-48ED-B045-F3C1A770F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866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B97E8E1-30BB-40F0-B158-331500ADE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8E422BE6-F6D9-41F3-80E6-9B68C822AE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B3B9FA46-E7C0-427C-A436-81B05759CC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584D5D45-EC95-44DF-88A9-6500C3A20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DADC44E-AFF9-44C1-8935-457ECFD46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7175D38D-DD2F-45DE-9BED-3034A9110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806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266F82F-8738-4183-9FD0-C69AAB5AF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E9EB5684-2AE0-4B0A-8DE2-3E146B8167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A7E5D40E-50C5-4C2D-A935-A01BB1FE0D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CA70508-C59F-4FA9-B560-7574EBACE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3626E0F1-4749-4904-93F5-0F30798E7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56D9221B-AC26-4E93-91DB-4B4769122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563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3BBB3994-F3AE-4182-87A8-3A4E2E33A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952B2427-B3CA-4F80-9249-C1FA79C82D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81FFDB0-E7E5-49FA-85FE-FA41BEADE6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E90C9-E738-409D-9614-78851F040AF5}" type="datetimeFigureOut">
              <a:rPr kumimoji="1" lang="ja-JP" altLang="en-US" smtClean="0"/>
              <a:t>2022/4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FF66C84-80C4-4914-92B5-0A724DA2DF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0F29601-6E55-411D-A859-BBA6A51B2B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13685-0609-4154-8BF5-11252BE6DB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8319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sv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矢印: 左右 23">
            <a:extLst>
              <a:ext uri="{FF2B5EF4-FFF2-40B4-BE49-F238E27FC236}">
                <a16:creationId xmlns:a16="http://schemas.microsoft.com/office/drawing/2014/main" xmlns="" id="{1B3F4E4B-2DDA-4A90-8713-419B4BABB764}"/>
              </a:ext>
            </a:extLst>
          </p:cNvPr>
          <p:cNvSpPr/>
          <p:nvPr/>
        </p:nvSpPr>
        <p:spPr>
          <a:xfrm>
            <a:off x="817034" y="3555966"/>
            <a:ext cx="3210650" cy="588597"/>
          </a:xfrm>
          <a:prstGeom prst="leftRightArrow">
            <a:avLst>
              <a:gd name="adj1" fmla="val 36238"/>
              <a:gd name="adj2" fmla="val 72018"/>
            </a:avLst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3399F910-66B8-42B4-B142-9A882B5E3E4F}"/>
              </a:ext>
            </a:extLst>
          </p:cNvPr>
          <p:cNvSpPr txBox="1"/>
          <p:nvPr/>
        </p:nvSpPr>
        <p:spPr>
          <a:xfrm>
            <a:off x="2926513" y="2260482"/>
            <a:ext cx="2405462" cy="307777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LT 2 Inhibitor User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矢印: 右 2">
            <a:extLst>
              <a:ext uri="{FF2B5EF4-FFF2-40B4-BE49-F238E27FC236}">
                <a16:creationId xmlns:a16="http://schemas.microsoft.com/office/drawing/2014/main" xmlns="" id="{28BBAFA3-90B5-453F-9803-6FFE783149F3}"/>
              </a:ext>
            </a:extLst>
          </p:cNvPr>
          <p:cNvSpPr/>
          <p:nvPr/>
        </p:nvSpPr>
        <p:spPr>
          <a:xfrm>
            <a:off x="6195110" y="3428975"/>
            <a:ext cx="5399992" cy="843280"/>
          </a:xfrm>
          <a:prstGeom prst="rightArrow">
            <a:avLst/>
          </a:prstGeom>
          <a:gradFill flip="none" rotWithShape="1">
            <a:gsLst>
              <a:gs pos="29000">
                <a:schemeClr val="accent1"/>
              </a:gs>
              <a:gs pos="63000">
                <a:srgbClr val="00B0F0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矢印: 右 6">
            <a:extLst>
              <a:ext uri="{FF2B5EF4-FFF2-40B4-BE49-F238E27FC236}">
                <a16:creationId xmlns:a16="http://schemas.microsoft.com/office/drawing/2014/main" xmlns="" id="{3B102169-0E89-41AB-B268-22A8059A7A01}"/>
              </a:ext>
            </a:extLst>
          </p:cNvPr>
          <p:cNvSpPr/>
          <p:nvPr/>
        </p:nvSpPr>
        <p:spPr>
          <a:xfrm rot="16200000">
            <a:off x="771317" y="4464387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xmlns="" id="{28AC9567-3C72-467D-9D89-D02C23EA0FB2}"/>
              </a:ext>
            </a:extLst>
          </p:cNvPr>
          <p:cNvSpPr/>
          <p:nvPr/>
        </p:nvSpPr>
        <p:spPr>
          <a:xfrm rot="16200000">
            <a:off x="3833137" y="4464387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B55DE679-4F5F-4B73-A78E-27C38B8888CF}"/>
              </a:ext>
            </a:extLst>
          </p:cNvPr>
          <p:cNvSpPr txBox="1"/>
          <p:nvPr/>
        </p:nvSpPr>
        <p:spPr>
          <a:xfrm>
            <a:off x="6275491" y="3686567"/>
            <a:ext cx="25651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servation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5617DECE-8115-4427-8500-C5209685AA35}"/>
              </a:ext>
            </a:extLst>
          </p:cNvPr>
          <p:cNvSpPr txBox="1"/>
          <p:nvPr/>
        </p:nvSpPr>
        <p:spPr>
          <a:xfrm>
            <a:off x="1631251" y="3696727"/>
            <a:ext cx="163152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ok-Back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D1AFB7FD-974F-426A-BACA-E5DDE0964FCB}"/>
              </a:ext>
            </a:extLst>
          </p:cNvPr>
          <p:cNvSpPr txBox="1"/>
          <p:nvPr/>
        </p:nvSpPr>
        <p:spPr>
          <a:xfrm>
            <a:off x="2964151" y="4924698"/>
            <a:ext cx="221928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cription</a:t>
            </a:r>
          </a:p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e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84035252-E4F3-4CB9-B522-C4F26F4EF4A6}"/>
              </a:ext>
            </a:extLst>
          </p:cNvPr>
          <p:cNvSpPr txBox="1"/>
          <p:nvPr/>
        </p:nvSpPr>
        <p:spPr>
          <a:xfrm>
            <a:off x="1471241" y="4069148"/>
            <a:ext cx="19257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 least four months)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8" name="グラフィックス 57" descr="グループ">
            <a:extLst>
              <a:ext uri="{FF2B5EF4-FFF2-40B4-BE49-F238E27FC236}">
                <a16:creationId xmlns:a16="http://schemas.microsoft.com/office/drawing/2014/main" xmlns="" id="{26CE258B-8158-43E0-9AFF-BFE5F4D1EFD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3"/>
              </a:ext>
            </a:extLst>
          </a:blip>
          <a:srcRect l="7122" t="17520" r="4218" b="21539"/>
          <a:stretch/>
        </p:blipFill>
        <p:spPr>
          <a:xfrm flipH="1">
            <a:off x="4095418" y="2834190"/>
            <a:ext cx="1038286" cy="713655"/>
          </a:xfrm>
          <a:prstGeom prst="rect">
            <a:avLst/>
          </a:prstGeom>
        </p:spPr>
      </p:pic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D7BEEE2D-04D3-4B6B-A0D3-D79ECB8242AF}"/>
              </a:ext>
            </a:extLst>
          </p:cNvPr>
          <p:cNvSpPr txBox="1"/>
          <p:nvPr/>
        </p:nvSpPr>
        <p:spPr>
          <a:xfrm>
            <a:off x="194587" y="4924699"/>
            <a:ext cx="161488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urance</a:t>
            </a:r>
          </a:p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erage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4DB7D66D-DD2E-4879-991C-000EA48B54F7}"/>
              </a:ext>
            </a:extLst>
          </p:cNvPr>
          <p:cNvSpPr txBox="1"/>
          <p:nvPr/>
        </p:nvSpPr>
        <p:spPr>
          <a:xfrm>
            <a:off x="8526419" y="4376925"/>
            <a:ext cx="2680390" cy="1569660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 Endpoint 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rt Failure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ocardial Infarction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gina Pectoris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oke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rial Fibrillation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グラフィックス 27" descr="グループ">
            <a:extLst>
              <a:ext uri="{FF2B5EF4-FFF2-40B4-BE49-F238E27FC236}">
                <a16:creationId xmlns:a16="http://schemas.microsoft.com/office/drawing/2014/main" xmlns="" id="{74D80B6B-3B3B-433F-9F8E-D51F345C7EA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3"/>
              </a:ext>
            </a:extLst>
          </a:blip>
          <a:srcRect l="7122" t="17520" r="4218" b="21539"/>
          <a:stretch/>
        </p:blipFill>
        <p:spPr>
          <a:xfrm flipH="1">
            <a:off x="3112901" y="2834190"/>
            <a:ext cx="1038286" cy="713655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2514C7F2-51D1-431D-B817-2F323D9F0B27}"/>
              </a:ext>
            </a:extLst>
          </p:cNvPr>
          <p:cNvSpPr txBox="1"/>
          <p:nvPr/>
        </p:nvSpPr>
        <p:spPr>
          <a:xfrm>
            <a:off x="7295673" y="1592412"/>
            <a:ext cx="3086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agliflozin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18008AE7-46BD-4BA6-80B7-BBB022B2C891}"/>
              </a:ext>
            </a:extLst>
          </p:cNvPr>
          <p:cNvSpPr txBox="1"/>
          <p:nvPr/>
        </p:nvSpPr>
        <p:spPr>
          <a:xfrm>
            <a:off x="7295673" y="935904"/>
            <a:ext cx="3086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pagliflozin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681D105F-C84F-4C08-8A46-A7333428C160}"/>
              </a:ext>
            </a:extLst>
          </p:cNvPr>
          <p:cNvSpPr txBox="1"/>
          <p:nvPr/>
        </p:nvSpPr>
        <p:spPr>
          <a:xfrm>
            <a:off x="7295673" y="2371922"/>
            <a:ext cx="3086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agliflozin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グラフィックス 38" descr="男性と女性">
            <a:extLst>
              <a:ext uri="{FF2B5EF4-FFF2-40B4-BE49-F238E27FC236}">
                <a16:creationId xmlns:a16="http://schemas.microsoft.com/office/drawing/2014/main" xmlns="" id="{D21C2439-FA29-4BD4-A5B4-03376D6CD5E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6514079" y="719750"/>
            <a:ext cx="796434" cy="796434"/>
          </a:xfrm>
          <a:prstGeom prst="rect">
            <a:avLst/>
          </a:prstGeom>
        </p:spPr>
      </p:pic>
      <p:pic>
        <p:nvPicPr>
          <p:cNvPr id="40" name="グラフィックス 39" descr="男性と女性">
            <a:extLst>
              <a:ext uri="{FF2B5EF4-FFF2-40B4-BE49-F238E27FC236}">
                <a16:creationId xmlns:a16="http://schemas.microsoft.com/office/drawing/2014/main" xmlns="" id="{24F77B06-DB85-4104-891E-9AEA6021351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6514079" y="1439588"/>
            <a:ext cx="796434" cy="796434"/>
          </a:xfrm>
          <a:prstGeom prst="rect">
            <a:avLst/>
          </a:prstGeom>
        </p:spPr>
      </p:pic>
      <p:pic>
        <p:nvPicPr>
          <p:cNvPr id="41" name="グラフィックス 40" descr="男性と女性">
            <a:extLst>
              <a:ext uri="{FF2B5EF4-FFF2-40B4-BE49-F238E27FC236}">
                <a16:creationId xmlns:a16="http://schemas.microsoft.com/office/drawing/2014/main" xmlns="" id="{EAE1B386-64A1-4A62-8BDF-A7D340A0FF7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6514079" y="2143278"/>
            <a:ext cx="796434" cy="796434"/>
          </a:xfrm>
          <a:prstGeom prst="rect">
            <a:avLst/>
          </a:prstGeom>
        </p:spPr>
      </p:pic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xmlns="" id="{440D1D03-2D38-4BB1-84D0-F4BB2B54E973}"/>
              </a:ext>
            </a:extLst>
          </p:cNvPr>
          <p:cNvCxnSpPr>
            <a:cxnSpLocks/>
            <a:endCxn id="44" idx="1"/>
          </p:cNvCxnSpPr>
          <p:nvPr/>
        </p:nvCxnSpPr>
        <p:spPr>
          <a:xfrm>
            <a:off x="5158694" y="3261160"/>
            <a:ext cx="1355385" cy="7740"/>
          </a:xfrm>
          <a:prstGeom prst="straightConnector1">
            <a:avLst/>
          </a:prstGeom>
          <a:ln w="25400">
            <a:solidFill>
              <a:srgbClr val="0070C0"/>
            </a:solidFill>
            <a:headEnd type="none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xmlns="" id="{5D6D343B-2B95-4530-9750-7E12216A4DB3}"/>
              </a:ext>
            </a:extLst>
          </p:cNvPr>
          <p:cNvCxnSpPr>
            <a:cxnSpLocks/>
            <a:endCxn id="40" idx="1"/>
          </p:cNvCxnSpPr>
          <p:nvPr/>
        </p:nvCxnSpPr>
        <p:spPr>
          <a:xfrm flipV="1">
            <a:off x="5670576" y="1837805"/>
            <a:ext cx="843503" cy="1378760"/>
          </a:xfrm>
          <a:prstGeom prst="straightConnector1">
            <a:avLst/>
          </a:prstGeom>
          <a:ln w="25400">
            <a:solidFill>
              <a:srgbClr val="0070C0"/>
            </a:solidFill>
            <a:headEnd type="none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xmlns="" id="{F5888CB3-1B39-4850-856B-C5C7A8084161}"/>
              </a:ext>
            </a:extLst>
          </p:cNvPr>
          <p:cNvCxnSpPr>
            <a:cxnSpLocks/>
            <a:endCxn id="41" idx="1"/>
          </p:cNvCxnSpPr>
          <p:nvPr/>
        </p:nvCxnSpPr>
        <p:spPr>
          <a:xfrm flipV="1">
            <a:off x="5645658" y="2541495"/>
            <a:ext cx="868421" cy="719665"/>
          </a:xfrm>
          <a:prstGeom prst="straightConnector1">
            <a:avLst/>
          </a:prstGeom>
          <a:ln w="25400">
            <a:solidFill>
              <a:srgbClr val="0070C0"/>
            </a:solidFill>
            <a:headEnd type="none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63BE364A-CB10-4F59-8913-64948541D46E}"/>
              </a:ext>
            </a:extLst>
          </p:cNvPr>
          <p:cNvSpPr txBox="1"/>
          <p:nvPr/>
        </p:nvSpPr>
        <p:spPr>
          <a:xfrm>
            <a:off x="162937" y="110447"/>
            <a:ext cx="81902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20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20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1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Study Design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681D105F-C84F-4C08-8A46-A7333428C160}"/>
              </a:ext>
            </a:extLst>
          </p:cNvPr>
          <p:cNvSpPr txBox="1"/>
          <p:nvPr/>
        </p:nvSpPr>
        <p:spPr>
          <a:xfrm>
            <a:off x="7295673" y="3099327"/>
            <a:ext cx="47954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hers (Ipragliflozin/Tofogliflozin/Luseogliflozin)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4" name="グラフィックス 40" descr="男性と女性">
            <a:extLst>
              <a:ext uri="{FF2B5EF4-FFF2-40B4-BE49-F238E27FC236}">
                <a16:creationId xmlns:a16="http://schemas.microsoft.com/office/drawing/2014/main" xmlns="" id="{EAE1B386-64A1-4A62-8BDF-A7D340A0FF7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6514079" y="2870683"/>
            <a:ext cx="796434" cy="796434"/>
          </a:xfrm>
          <a:prstGeom prst="rect">
            <a:avLst/>
          </a:prstGeom>
        </p:spPr>
      </p:pic>
      <p:sp>
        <p:nvSpPr>
          <p:cNvPr id="4" name="正方形/長方形 3"/>
          <p:cNvSpPr/>
          <p:nvPr/>
        </p:nvSpPr>
        <p:spPr>
          <a:xfrm>
            <a:off x="4037368" y="3639229"/>
            <a:ext cx="56269" cy="40280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矢印: 左右 23">
            <a:extLst>
              <a:ext uri="{FF2B5EF4-FFF2-40B4-BE49-F238E27FC236}">
                <a16:creationId xmlns:a16="http://schemas.microsoft.com/office/drawing/2014/main" xmlns="" id="{1B3F4E4B-2DDA-4A90-8713-419B4BABB764}"/>
              </a:ext>
            </a:extLst>
          </p:cNvPr>
          <p:cNvSpPr/>
          <p:nvPr/>
        </p:nvSpPr>
        <p:spPr>
          <a:xfrm>
            <a:off x="4110566" y="3555966"/>
            <a:ext cx="2084543" cy="588597"/>
          </a:xfrm>
          <a:prstGeom prst="leftRightArrow">
            <a:avLst>
              <a:gd name="adj1" fmla="val 36238"/>
              <a:gd name="adj2" fmla="val 72018"/>
            </a:avLst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5617DECE-8115-4427-8500-C5209685AA35}"/>
              </a:ext>
            </a:extLst>
          </p:cNvPr>
          <p:cNvSpPr txBox="1"/>
          <p:nvPr/>
        </p:nvSpPr>
        <p:spPr>
          <a:xfrm>
            <a:off x="4407942" y="3696727"/>
            <a:ext cx="150703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uction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84035252-E4F3-4CB9-B522-C4F26F4EF4A6}"/>
              </a:ext>
            </a:extLst>
          </p:cNvPr>
          <p:cNvSpPr txBox="1"/>
          <p:nvPr/>
        </p:nvSpPr>
        <p:spPr>
          <a:xfrm>
            <a:off x="4196110" y="4069148"/>
            <a:ext cx="19257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ne month)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xmlns="" id="{5D6D343B-2B95-4530-9750-7E12216A4DB3}"/>
              </a:ext>
            </a:extLst>
          </p:cNvPr>
          <p:cNvCxnSpPr>
            <a:cxnSpLocks/>
            <a:endCxn id="39" idx="1"/>
          </p:cNvCxnSpPr>
          <p:nvPr/>
        </p:nvCxnSpPr>
        <p:spPr>
          <a:xfrm flipV="1">
            <a:off x="5648325" y="1117967"/>
            <a:ext cx="865754" cy="2136688"/>
          </a:xfrm>
          <a:prstGeom prst="straightConnector1">
            <a:avLst/>
          </a:prstGeom>
          <a:ln w="25400">
            <a:solidFill>
              <a:srgbClr val="0070C0"/>
            </a:solidFill>
            <a:headEnd type="none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076330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6226869"/>
              </p:ext>
            </p:extLst>
          </p:nvPr>
        </p:nvGraphicFramePr>
        <p:xfrm>
          <a:off x="103220" y="302889"/>
          <a:ext cx="11850063" cy="36576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616250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661625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33008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52437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5272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5272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5272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886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604041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3239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4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9 (43.9-73.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4.5 (51.0-81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3 (0.80-1.6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2-1.6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77-1.5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0 (42.9-73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8 (0.68-1.4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68-1.4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66-1.4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pr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27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6.5 (53.9-82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3-1.6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3-1.6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76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of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07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3.8 (39.9-72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3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5 (0.64-1.4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59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0798644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Luse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7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1.4 (35.7-74.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0 (0.58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59-1.4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9 (0.57-1.4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91252422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6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.8 (20.9-42.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0.1 (13.2-30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 (0.37-1.13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 (0.38-1.14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 (0.36-1.10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.9 (19.1-40.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 (0.55-1.55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 (0.54-1.54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 (0.54-1.53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pr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27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0.5 (14.0-29.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 (0.39-1.1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 (0.39-1.1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 (0.37-1.07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of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07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1.2 (21.1-46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 (0.58-1.70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 (0.59-1.7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 (0.57-1.68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0658733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Luse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7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.1 (7.1-28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 (0.21-1.00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 (0.21-1.0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 (0.21-1.0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27869751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0E86975A-5339-4F5D-88F4-75D1EE03F0A0}"/>
              </a:ext>
            </a:extLst>
          </p:cNvPr>
          <p:cNvSpPr txBox="1"/>
          <p:nvPr/>
        </p:nvSpPr>
        <p:spPr>
          <a:xfrm>
            <a:off x="10537" y="-36217"/>
            <a:ext cx="11850063" cy="339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9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Comparison of Six SGLT2 Inhibitors)</a:t>
            </a: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34975701"/>
              </p:ext>
            </p:extLst>
          </p:nvPr>
        </p:nvGraphicFramePr>
        <p:xfrm>
          <a:off x="7211240" y="519765"/>
          <a:ext cx="3262840" cy="3737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88732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4769574"/>
              </p:ext>
            </p:extLst>
          </p:nvPr>
        </p:nvGraphicFramePr>
        <p:xfrm>
          <a:off x="104400" y="302400"/>
          <a:ext cx="11973215" cy="6339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21096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63418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260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599626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8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08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9.6 (126.1-177.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8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5.1 (122.6-171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73-1.18) 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74-1.2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5 (0.75-1.2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0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6.7 (141.5-196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9 (0.86-1.3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86-1.3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1 (0.87-1.4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02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1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8.1 (123.7-154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71-1.0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72-1.0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0 (0.73-1.1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3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08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8.0 (18.9-41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8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.3 (17.0-37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6 (0.49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50-1.5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8 (0.44-1.3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0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.8 (18.7-41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55-1.7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55-1.6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9 (0.50-1.5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02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9.1-31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51-1.3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3 (0.51-1.3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45-1.1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8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08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0.5 (117.7-167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8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2.4 (120.0-168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1 (0.79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80-1.3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75-1.2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0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3.0 (119.7-170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79-1.3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79-1.3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77-1.2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437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02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2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9.8 (125.3-155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81-1.2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0 (0.81-1.2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75-1.1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7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427954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08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4 (42.8-74.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9051534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8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2 (42.9-73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0 (0.68-1.4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70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66-1.4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716573452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0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4.7 (41.1-72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65-1.4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65-1.4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5 (0.64-1.4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671131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02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8 (48.0-67.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0 (0.72-1.3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73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8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380358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4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6159979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08 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.2 (20.0-42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92957361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8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9.0 (11.9-30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2 (0.34-1.1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3 (0.35-1.1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1 (0.33-1.1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86431969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70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.5 (16.8-38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5 (0.48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6 (0.49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5 (0.48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21269108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,02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3.4 (18.0-30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6 (0.48-1.2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8 (0.48-1.2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5 (0.46-1.2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7790177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AC73B6E-C45C-4B0C-993C-6B00EB707A0B}"/>
              </a:ext>
            </a:extLst>
          </p:cNvPr>
          <p:cNvSpPr txBox="1"/>
          <p:nvPr/>
        </p:nvSpPr>
        <p:spPr>
          <a:xfrm>
            <a:off x="10537" y="-36216"/>
            <a:ext cx="11697759" cy="3386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2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Continuous Prescription Group)</a:t>
            </a:r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7432211"/>
              </p:ext>
            </p:extLst>
          </p:nvPr>
        </p:nvGraphicFramePr>
        <p:xfrm>
          <a:off x="7350020" y="528320"/>
          <a:ext cx="3262840" cy="64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6452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52076"/>
              </p:ext>
            </p:extLst>
          </p:nvPr>
        </p:nvGraphicFramePr>
        <p:xfrm>
          <a:off x="109393" y="295200"/>
          <a:ext cx="11973215" cy="6339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29563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54951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260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599626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155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87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7.7 (133.8-185.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6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4.1 (131.5-180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75-1.1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75-1.1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77-1.2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6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4.8 (140.0-194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81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81-1.2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83-1.3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3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8.3 (124.4-153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3 (0.68-1.0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69-1.0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71-1.0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9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87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8.4 (19.3-41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6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6.7-36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47-1.4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47-1.4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2 (0.41-1.2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6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6.3-37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48-1.4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48-1.4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6 (0.43-1.3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5 (17.3-29.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2 (0.45-1.1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45-1.1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2 (0.38-1.0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87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6.5 (114.4-162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6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6.1 (133.3-182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4 (0.90-1.4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5 (0.91-1.4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4-1.3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6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7.0 (114.6-163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0 (0.78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0 (0.78-1.2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75-1.2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437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4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1.7 (127.5-157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4-1.2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5-1.2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5 (0.77-1.1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3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427954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87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4.8 (41.6-72.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9051534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6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3.7 (49.8-81.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0-1.6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9 (0.82-1.7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3 (0.78-1.6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716573452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6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8.7 (44.7-77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73-1.5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73-1.5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71-1.5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671131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8.4 (49.6-68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77-1.4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77-1.4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0 (0.72-1.3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380358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9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6159979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878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1.7 (22.0-45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92957361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36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0.7 (13.5-31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3 (0.36-1.1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4 (0.36-1.1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0 (0.34-1.0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86431969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6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.2 (19.9-42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1 (0.53-1.5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1 (0.53-1.5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9 (0.52-1.5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21269108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8 (17.6-29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0 (0.44-1.0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0 (0.45-1.1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7 (0.42-1.0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7790177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AC73B6E-C45C-4B0C-993C-6B00EB707A0B}"/>
              </a:ext>
            </a:extLst>
          </p:cNvPr>
          <p:cNvSpPr txBox="1"/>
          <p:nvPr/>
        </p:nvSpPr>
        <p:spPr>
          <a:xfrm>
            <a:off x="10537" y="-36216"/>
            <a:ext cx="103285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Figure S3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Induction Period ≥ 90 Days)</a:t>
            </a: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4445689"/>
              </p:ext>
            </p:extLst>
          </p:nvPr>
        </p:nvGraphicFramePr>
        <p:xfrm>
          <a:off x="7248420" y="487680"/>
          <a:ext cx="3262840" cy="6441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060442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5559410"/>
              </p:ext>
            </p:extLst>
          </p:nvPr>
        </p:nvGraphicFramePr>
        <p:xfrm>
          <a:off x="109393" y="295200"/>
          <a:ext cx="11973215" cy="6339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25330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59184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260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599626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10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93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7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.6 (137.0-183.6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27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9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  157.9 (137.2-181.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79-1.1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79-1.1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81-1.22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,95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  167.4 (144.8-193.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5-1.2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5-1.2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6-1.30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,28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3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  145.3 (132.4-159.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74-1.0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9 (0.75-1.0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1 (0.76-1.08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51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93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 (21.1-41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27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8 (17.4-35.2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1 (0.49-1.3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50-1.3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44-1.1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,95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9 (20.4-40.8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59-1.5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59-1.5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53-1.42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,28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81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3 (21.2-32.7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56-1.2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5 (0.49-1.1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5 (0.49-1.1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83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93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.7 (120.4-164.3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27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.8 (132.4-176.3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8 (0.88-1.3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9 (0.89-1.3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83-1.2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,95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.8 (129.4-175.7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86-1.3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9 (0.89-1.3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3-1.2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437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,28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40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.5 (133.4-160.8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7-1.2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87-1.2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80-1.17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42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427954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93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0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2 (48.4-77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9051534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27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4 (50.9-79.1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75-1.43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77-1.46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1 (0.73-1.40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716573452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,95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0 (44.6-73.0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66-1.3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66-1.3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65-1.2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671131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,28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3 (52.3-69.7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8 (0.74-1.2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75-1.30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70-1.24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380358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66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6159979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93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6 (21.1-41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92957361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27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9 (13.5-29.5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5 (0.39-1.0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6 (0.39-1.1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2 (0.37-1.0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864319698"/>
                  </a:ext>
                </a:extLst>
              </a:tr>
              <a:tr h="22864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,95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8 (20.4-40.8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59-1.5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5 (0.59-1.5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57-1.52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21269108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,287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3 (19.4-30.5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9 (0.53-1.19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0 (0.53-1.21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6 (0.50-1.15)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7790177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AC73B6E-C45C-4B0C-993C-6B00EB707A0B}"/>
              </a:ext>
            </a:extLst>
          </p:cNvPr>
          <p:cNvSpPr txBox="1"/>
          <p:nvPr/>
        </p:nvSpPr>
        <p:spPr>
          <a:xfrm>
            <a:off x="10537" y="-36217"/>
            <a:ext cx="114989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4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Multiple Imputations for Missing Data)</a:t>
            </a: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2153510"/>
              </p:ext>
            </p:extLst>
          </p:nvPr>
        </p:nvGraphicFramePr>
        <p:xfrm>
          <a:off x="7352156" y="519764"/>
          <a:ext cx="3262840" cy="640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94008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8117794"/>
              </p:ext>
            </p:extLst>
          </p:nvPr>
        </p:nvGraphicFramePr>
        <p:xfrm>
          <a:off x="109393" y="295200"/>
          <a:ext cx="11973215" cy="6339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54963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29551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260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599626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1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6.7 (133.9-183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7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9.7 (137.5-185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79-1.2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80-1.2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81-1.2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8.7 (144.5-197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5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5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8 (0.87-1.3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9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6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0.0 (126.5-155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6 (0.71-1.0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6 (0.71-1.0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73-1.0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5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.8 (18.4-39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7.0-36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51-1.4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52-1.5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7 (0.45-1.3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.9 (18.3-39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8 (0.57-1.6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8 (0.57-1.6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 (0.51-1.5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9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3.5 (18.3-30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1 (0.51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51-1.3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0 (0.43-1.1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3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8.4 (117.1-163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1.9 (130.2-177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87-1.3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1 (0.88-1.3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82-1.3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7.4 (124.9-174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84-1.3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7 (0.84-1.3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81-1.3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437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9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7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3.6 (129.8-158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5-1.2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6-1.2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79-1.1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9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427954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9 (43.9-73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9051534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4.5 (51.0-81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4 (0.80-1.6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2-1.6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77-1.5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716573452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.0 (42.9-73.1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68-1.4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68-1.4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6 (0.66-1.4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671131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9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9.5 (51.0-69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77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77-1.4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8 (0.71-1.3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380358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6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6159979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.8 (20.9-42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92957361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0.1 (13.2-30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5 (0.37-1.1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6 (0.38-1.1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3 (0.36-1.1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86431969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.9 (19.1-40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54-1.5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54-1.5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0 (0.53-1.5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21269108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92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3 (17.3-28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2 (0.46-1.1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47-1.1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0 (0.44-1.0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7790177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AC73B6E-C45C-4B0C-993C-6B00EB707A0B}"/>
              </a:ext>
            </a:extLst>
          </p:cNvPr>
          <p:cNvSpPr txBox="1"/>
          <p:nvPr/>
        </p:nvSpPr>
        <p:spPr>
          <a:xfrm>
            <a:off x="10537" y="-36216"/>
            <a:ext cx="10316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5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Competing Risks Model) </a:t>
            </a: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2784986"/>
              </p:ext>
            </p:extLst>
          </p:nvPr>
        </p:nvGraphicFramePr>
        <p:xfrm>
          <a:off x="7313657" y="510140"/>
          <a:ext cx="3262840" cy="6427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286938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2732379"/>
              </p:ext>
            </p:extLst>
          </p:nvPr>
        </p:nvGraphicFramePr>
        <p:xfrm>
          <a:off x="240632" y="557834"/>
          <a:ext cx="11733653" cy="15087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656115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799771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5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th</a:t>
                      </a:r>
                      <a:endParaRPr kumimoji="1" lang="ja-JP" altLang="en-US" sz="105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05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.9 (6.7-20.9)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0.0 (5.6-18.1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8 (0.34-1.78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9 (0.35-1.82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9 (0.39-2.04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9.3 (4.8-17.8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4 (0.31-1.77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5 (0.32-1.78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1 (0.34-1.94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921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0.0 (6.9-14.6)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5 (0.38-1.50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6 (0.38-1.52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43-1.75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0E86975A-5339-4F5D-88F4-75D1EE03F0A0}"/>
              </a:ext>
            </a:extLst>
          </p:cNvPr>
          <p:cNvSpPr txBox="1"/>
          <p:nvPr/>
        </p:nvSpPr>
        <p:spPr>
          <a:xfrm>
            <a:off x="10537" y="110447"/>
            <a:ext cx="81902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20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20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6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All-Cause Mortality among SGLT2 Inhibitors </a:t>
            </a: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4429581"/>
              </p:ext>
            </p:extLst>
          </p:nvPr>
        </p:nvGraphicFramePr>
        <p:xfrm>
          <a:off x="7179735" y="956733"/>
          <a:ext cx="3121552" cy="14119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24303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0678343"/>
              </p:ext>
            </p:extLst>
          </p:nvPr>
        </p:nvGraphicFramePr>
        <p:xfrm>
          <a:off x="109393" y="295200"/>
          <a:ext cx="11973215" cy="6339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25330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59184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260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599626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6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71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7.7 (133.8-185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3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4.1 (131.5-180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68-1.2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8-1.3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72-1.3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2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4.8 (140.0-194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5 (0.84-1.5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4-1.6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9 (0.87-1.6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59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8.3 (124.4-153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55-0.9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55-0.9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7 (0.57-1.0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1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71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8.4 (19.3-41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3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6.7-36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8 (0.51-2.3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51-2.3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42-1.9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2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6.3-37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7 (0.43-2.2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8 (0.43-2.2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1 (0.40-2.0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59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5 (17.3-29.2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5 (0.32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6 (0.33-1.3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53 (0.26-1.1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ja-JP" alt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71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6.5 (114.4-162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3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8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6.1 (133.3-182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0 (0.92-1.8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1 (0.94-1.8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22 (0.87-1.7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2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7.0 (114.6-163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4-1.3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5-1.3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5-1.3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437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59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1.7 (127.5-157.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3 (0.68-1.2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4 (0.69-1.2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6 (0.63-1.1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4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427954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71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4.8 (41.6-72.3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9051534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3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3.7 (49.8-81.4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8 (0.82-2.3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42 (0.85-2.3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42 (0.84-2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716573452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2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8.7 (44.7-77.0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59-1.8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59-1.8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59-1.8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671131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59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8.4 (49.6-68.7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65-1.6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5 (0.66-1.6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63-1.6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380358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9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6159979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71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1.7 (22.0-45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92957361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3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0.7 (13.5-31.8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43 (0.16-1.1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44 (0.16-1.1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43 (0.16-1.1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86431969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,2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9.2 (19.9-42.9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5 (0.63-2.8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6 (0.63-2.9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8 (0.65-2.9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21269108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,59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8 (17.6-29.6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0 (0.35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1 (0.35-1.4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0 (0.34-1.4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7790177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AC73B6E-C45C-4B0C-993C-6B00EB707A0B}"/>
              </a:ext>
            </a:extLst>
          </p:cNvPr>
          <p:cNvSpPr txBox="1"/>
          <p:nvPr/>
        </p:nvSpPr>
        <p:spPr>
          <a:xfrm>
            <a:off x="10537" y="-36216"/>
            <a:ext cx="1207207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7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Adjusted for Estimated Glomerular Filtration Rate)</a:t>
            </a: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753410"/>
              </p:ext>
            </p:extLst>
          </p:nvPr>
        </p:nvGraphicFramePr>
        <p:xfrm>
          <a:off x="7329700" y="518160"/>
          <a:ext cx="3262840" cy="64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50755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6136586"/>
              </p:ext>
            </p:extLst>
          </p:nvPr>
        </p:nvGraphicFramePr>
        <p:xfrm>
          <a:off x="109393" y="295200"/>
          <a:ext cx="11973215" cy="6339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88168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822476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25330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59184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4057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260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599626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0211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9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74.8 (147.5-207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39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2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3.5 (155.8-216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1 (0.80-1.2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81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3-1.3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18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3.9 (154.8-218.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81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81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3-1.3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,7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0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8.1 (141.3-176.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71-1.0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7 (0.71-1.0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75-1.1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9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3.5 (22.8-49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9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2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0.0 (20.1-44.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48-1.4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48-1.4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2 (0.41-1.2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18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4.9 (23.6-51.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1 (0.58-1.7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1 (0.58-1.7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0 (0.52-1.5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,7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8.5 (22.0-37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8 (0.49-1.2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8 (0.49-1.2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6 (0.40-1.0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9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2.3 (127.0-182.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2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79.8 (152.4-212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8 (0.92-1.5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9 (0.93-1.5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85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18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8.2 (140.4-201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1 (0.86-1.4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1 (0.86-1.4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2-1.3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437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,7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2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70.6 (153.0-190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2 (0.91-1.3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2 (0.91-1.3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3 (0.83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k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427954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9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9.6 (44.6-79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1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90515346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2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9.3 (61.9-101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4 (0.91-1.9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5 (0.92-1.9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30 (0.88-1.9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716573452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18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7.3 (50.7-89.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3 (0.75-1.7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4 (0.76-1.7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3 (0.75-1.6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67113193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,7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69.2 (58.4-81.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3-1.6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6 (0.83-1.6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10 (0.78-1.5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3803580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rial Fibrilla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61599795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9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40.0 (20.7-46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67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92957361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29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9 (16.1-38.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7 (0.42-1.4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7 (0.43-1.4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3 (0.40-1.3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864319698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,18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3.5 (22.4-49.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60-1.8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60-1.8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4 (0.59-1.8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212691089"/>
                  </a:ext>
                </a:extLst>
              </a:tr>
              <a:tr h="20211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Other SGLT2-Inhibitors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,71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.5 (20.2-34.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50-1.3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2 (0.50-1.3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8 (0.47-1.2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7790177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5AC73B6E-C45C-4B0C-993C-6B00EB707A0B}"/>
              </a:ext>
            </a:extLst>
          </p:cNvPr>
          <p:cNvSpPr txBox="1"/>
          <p:nvPr/>
        </p:nvSpPr>
        <p:spPr>
          <a:xfrm>
            <a:off x="10537" y="-36216"/>
            <a:ext cx="1218146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</a:t>
            </a: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8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Individuals with Diagnosis of Type 2 Diabetes Mellitus)</a:t>
            </a: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/>
        </p:nvGraphicFramePr>
        <p:xfrm>
          <a:off x="7146000" y="527200"/>
          <a:ext cx="3262840" cy="6410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89712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xmlns="" id="{90529AC4-44FE-42AB-B122-50019C1F05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6055596"/>
              </p:ext>
            </p:extLst>
          </p:nvPr>
        </p:nvGraphicFramePr>
        <p:xfrm>
          <a:off x="103220" y="302889"/>
          <a:ext cx="11850063" cy="53644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616250">
                  <a:extLst>
                    <a:ext uri="{9D8B030D-6E8A-4147-A177-3AD203B41FA5}">
                      <a16:colId xmlns:a16="http://schemas.microsoft.com/office/drawing/2014/main" xmlns="" val="2383592539"/>
                    </a:ext>
                  </a:extLst>
                </a:gridCol>
                <a:gridCol w="661625">
                  <a:extLst>
                    <a:ext uri="{9D8B030D-6E8A-4147-A177-3AD203B41FA5}">
                      <a16:colId xmlns:a16="http://schemas.microsoft.com/office/drawing/2014/main" xmlns="" val="3053380440"/>
                    </a:ext>
                  </a:extLst>
                </a:gridCol>
                <a:gridCol w="633008">
                  <a:extLst>
                    <a:ext uri="{9D8B030D-6E8A-4147-A177-3AD203B41FA5}">
                      <a16:colId xmlns:a16="http://schemas.microsoft.com/office/drawing/2014/main" xmlns="" val="393859822"/>
                    </a:ext>
                  </a:extLst>
                </a:gridCol>
                <a:gridCol w="1252437">
                  <a:extLst>
                    <a:ext uri="{9D8B030D-6E8A-4147-A177-3AD203B41FA5}">
                      <a16:colId xmlns:a16="http://schemas.microsoft.com/office/drawing/2014/main" xmlns="" val="2787533868"/>
                    </a:ext>
                  </a:extLst>
                </a:gridCol>
                <a:gridCol w="1075272">
                  <a:extLst>
                    <a:ext uri="{9D8B030D-6E8A-4147-A177-3AD203B41FA5}">
                      <a16:colId xmlns:a16="http://schemas.microsoft.com/office/drawing/2014/main" xmlns="" val="1992937632"/>
                    </a:ext>
                  </a:extLst>
                </a:gridCol>
                <a:gridCol w="1075272">
                  <a:extLst>
                    <a:ext uri="{9D8B030D-6E8A-4147-A177-3AD203B41FA5}">
                      <a16:colId xmlns:a16="http://schemas.microsoft.com/office/drawing/2014/main" xmlns="" val="81910823"/>
                    </a:ext>
                  </a:extLst>
                </a:gridCol>
                <a:gridCol w="1075272">
                  <a:extLst>
                    <a:ext uri="{9D8B030D-6E8A-4147-A177-3AD203B41FA5}">
                      <a16:colId xmlns:a16="http://schemas.microsoft.com/office/drawing/2014/main" xmlns="" val="3255893901"/>
                    </a:ext>
                  </a:extLst>
                </a:gridCol>
                <a:gridCol w="2856886">
                  <a:extLst>
                    <a:ext uri="{9D8B030D-6E8A-4147-A177-3AD203B41FA5}">
                      <a16:colId xmlns:a16="http://schemas.microsoft.com/office/drawing/2014/main" xmlns="" val="2961509832"/>
                    </a:ext>
                  </a:extLst>
                </a:gridCol>
                <a:gridCol w="1604041">
                  <a:extLst>
                    <a:ext uri="{9D8B030D-6E8A-4147-A177-3AD203B41FA5}">
                      <a16:colId xmlns:a16="http://schemas.microsoft.com/office/drawing/2014/main" xmlns="" val="3170789469"/>
                    </a:ext>
                  </a:extLst>
                </a:gridCol>
              </a:tblGrid>
              <a:tr h="232390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vents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zard Ratio (95% Confidence Interval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38075191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rt Failure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3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4085580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6.7 (133.9-183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663676993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7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9.7 (137.5-185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79-1.23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9 (0.80-1.2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2 (0.82-1.2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737735469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8.7 (144.5-197.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5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6 (0.85-1.3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.08 (0.87-1.3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13020884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pr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27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9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7.1 (127.6-169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0 (0.72-1.1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0 (0.72-1.1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92 (0.74-1.1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056579116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of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07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0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7.0 (113.5-165.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65-1.07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4 (0.66-1.08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6 (0.67-1.1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90798644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Luse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7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8.0 (101.4-161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79 (0.60-1.0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0 (0.60-1.0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3 (0.62-1.1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091252422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cardial Infarction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6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1120349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.8 (18.4-39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8890863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4.7 (17.0-36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 (0.51-1.49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 (0.51-1.5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 (0.45-1.3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25988268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.9 (18.3-39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 (0.57-1.68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 (0.57-1.67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 (0.51-1.5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50379375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pr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27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2.8 (15.9-32.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 (0.46-1.3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 (0.46-1.3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 (0.38-1.1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32370951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of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07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6.2 (17.1-40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 (0.51-1.6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 (0.51-1.6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 (0.43-1.39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0658733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Luse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7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21.2 (12.1-37.4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 (0.38-1.49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 (0.39-1.5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 (0.35-1.38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027869751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na Pectori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00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338289674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Em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38.4 (117.1-163.6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[Reference]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506217138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Dap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8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6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51.9 (130.2-177.1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 (0.87-1.38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 (0.88-1.39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 (0.82-1.30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245186006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an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11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7.4 (124.9-174.0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 (0.84-1.35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 (0.84-1.35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 (0.81-1.30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40337577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Ipra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275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8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4.8 (125.4-167.2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 (0.84-1.3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 (0.84-1.31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 (0.76-1.19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560097510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of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074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1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1.9 (117.8-170.9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 (0.80-1.3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 (0.80-1.33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 (0.73-1.2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806699461"/>
                  </a:ext>
                </a:extLst>
              </a:tr>
              <a:tr h="23239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Luseogliflozin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572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143.2 (114.9-178.5)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 (0.78-1.36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 (0.80-1.39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 (0.76-1.32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436276769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0E86975A-5339-4F5D-88F4-75D1EE03F0A0}"/>
              </a:ext>
            </a:extLst>
          </p:cNvPr>
          <p:cNvSpPr txBox="1"/>
          <p:nvPr/>
        </p:nvSpPr>
        <p:spPr>
          <a:xfrm>
            <a:off x="10537" y="-36217"/>
            <a:ext cx="11850063" cy="339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6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dditional file 1: Figure S9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Risk of Cardiovascular Event among SGLT2 Inhibitors (Comparison of Six SGLT2 Inhibitors)</a:t>
            </a: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xmlns="" id="{D1200439-CA8E-4D9C-9D32-E624089BF7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6513030"/>
              </p:ext>
            </p:extLst>
          </p:nvPr>
        </p:nvGraphicFramePr>
        <p:xfrm>
          <a:off x="7187460" y="529389"/>
          <a:ext cx="3262840" cy="5433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11565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41</TotalTime>
  <Words>3617</Words>
  <Application>Microsoft Office PowerPoint</Application>
  <PresentationFormat>Widescreen</PresentationFormat>
  <Paragraphs>1252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游ゴシック</vt:lpstr>
      <vt:lpstr>游ゴシック</vt:lpstr>
      <vt:lpstr>游ゴシック Light</vt:lpstr>
      <vt:lpstr>Arial</vt:lpstr>
      <vt:lpstr>Times New Roman</vt:lpstr>
      <vt:lpstr>Wingdings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子 英弘</dc:creator>
  <cp:lastModifiedBy>ANGEL PRECILLA</cp:lastModifiedBy>
  <cp:revision>84</cp:revision>
  <dcterms:created xsi:type="dcterms:W3CDTF">2022-02-02T01:15:27Z</dcterms:created>
  <dcterms:modified xsi:type="dcterms:W3CDTF">2022-04-28T11:48:44Z</dcterms:modified>
</cp:coreProperties>
</file>